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7"/>
  </p:handoutMasterIdLst>
  <p:sldIdLst>
    <p:sldId id="302" r:id="rId2"/>
    <p:sldId id="305" r:id="rId3"/>
    <p:sldId id="272" r:id="rId4"/>
    <p:sldId id="270" r:id="rId5"/>
    <p:sldId id="303" r:id="rId6"/>
  </p:sldIdLst>
  <p:sldSz cx="6858000" cy="9144000" type="screen4x3"/>
  <p:notesSz cx="6889750" cy="100218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496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tsuya\Dropbox\SM\paper33(Murakami)\&#26449;&#19978;&#20934;&#21490;&#23455;&#39443;\Murakami%20&#20462;&#22763;\&#27671;&#35937;&#12487;&#12540;&#12479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tsuya\Dropbox\SM\paper33(Murakami)\&#26449;&#19978;&#20934;&#21490;&#23455;&#39443;\Murakami%20&#20462;&#22763;\&#27671;&#35937;&#12487;&#12540;&#12479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/>
      <c:lineChart>
        <c:grouping val="standard"/>
        <c:ser>
          <c:idx val="2"/>
          <c:order val="0"/>
          <c:tx>
            <c:strRef>
              <c:f>'2015'!$E$1</c:f>
              <c:strCache>
                <c:ptCount val="1"/>
                <c:pt idx="0">
                  <c:v>最高気温</c:v>
                </c:pt>
              </c:strCache>
            </c:strRef>
          </c:tx>
          <c:spPr>
            <a:ln w="19050">
              <a:solidFill>
                <a:schemeClr val="tx1">
                  <a:lumMod val="95000"/>
                  <a:lumOff val="5000"/>
                </a:schemeClr>
              </a:solidFill>
            </a:ln>
          </c:spPr>
          <c:marker>
            <c:symbol val="none"/>
          </c:marker>
          <c:cat>
            <c:numRef>
              <c:f>'2015'!$B$29:$B$154</c:f>
              <c:numCache>
                <c:formatCode>mm"月"dd"日"</c:formatCode>
                <c:ptCount val="126"/>
                <c:pt idx="0">
                  <c:v>42152</c:v>
                </c:pt>
                <c:pt idx="1">
                  <c:v>42153</c:v>
                </c:pt>
                <c:pt idx="2">
                  <c:v>42154</c:v>
                </c:pt>
                <c:pt idx="3">
                  <c:v>42155</c:v>
                </c:pt>
                <c:pt idx="4">
                  <c:v>42156</c:v>
                </c:pt>
                <c:pt idx="5">
                  <c:v>42157</c:v>
                </c:pt>
                <c:pt idx="6">
                  <c:v>42158</c:v>
                </c:pt>
                <c:pt idx="7">
                  <c:v>42159</c:v>
                </c:pt>
                <c:pt idx="8">
                  <c:v>42160</c:v>
                </c:pt>
                <c:pt idx="9">
                  <c:v>42161</c:v>
                </c:pt>
                <c:pt idx="10">
                  <c:v>42162</c:v>
                </c:pt>
                <c:pt idx="11">
                  <c:v>42163</c:v>
                </c:pt>
                <c:pt idx="12">
                  <c:v>42164</c:v>
                </c:pt>
                <c:pt idx="13">
                  <c:v>42165</c:v>
                </c:pt>
                <c:pt idx="14">
                  <c:v>42166</c:v>
                </c:pt>
                <c:pt idx="15">
                  <c:v>42167</c:v>
                </c:pt>
                <c:pt idx="16">
                  <c:v>42168</c:v>
                </c:pt>
                <c:pt idx="17">
                  <c:v>42169</c:v>
                </c:pt>
                <c:pt idx="18">
                  <c:v>42170</c:v>
                </c:pt>
                <c:pt idx="19">
                  <c:v>42171</c:v>
                </c:pt>
                <c:pt idx="20">
                  <c:v>42172</c:v>
                </c:pt>
                <c:pt idx="21">
                  <c:v>42173</c:v>
                </c:pt>
                <c:pt idx="22">
                  <c:v>42174</c:v>
                </c:pt>
                <c:pt idx="23">
                  <c:v>42175</c:v>
                </c:pt>
                <c:pt idx="24">
                  <c:v>42176</c:v>
                </c:pt>
                <c:pt idx="25">
                  <c:v>42177</c:v>
                </c:pt>
                <c:pt idx="26">
                  <c:v>42178</c:v>
                </c:pt>
                <c:pt idx="27">
                  <c:v>42179</c:v>
                </c:pt>
                <c:pt idx="28">
                  <c:v>42180</c:v>
                </c:pt>
                <c:pt idx="29">
                  <c:v>42181</c:v>
                </c:pt>
                <c:pt idx="30">
                  <c:v>42182</c:v>
                </c:pt>
                <c:pt idx="31">
                  <c:v>42183</c:v>
                </c:pt>
                <c:pt idx="32">
                  <c:v>42184</c:v>
                </c:pt>
                <c:pt idx="33">
                  <c:v>42185</c:v>
                </c:pt>
                <c:pt idx="34">
                  <c:v>42186</c:v>
                </c:pt>
                <c:pt idx="35">
                  <c:v>42187</c:v>
                </c:pt>
                <c:pt idx="36">
                  <c:v>42188</c:v>
                </c:pt>
                <c:pt idx="37">
                  <c:v>42189</c:v>
                </c:pt>
                <c:pt idx="38">
                  <c:v>42190</c:v>
                </c:pt>
                <c:pt idx="39">
                  <c:v>42191</c:v>
                </c:pt>
                <c:pt idx="40">
                  <c:v>42192</c:v>
                </c:pt>
                <c:pt idx="41">
                  <c:v>42193</c:v>
                </c:pt>
                <c:pt idx="42">
                  <c:v>42194</c:v>
                </c:pt>
                <c:pt idx="43">
                  <c:v>42195</c:v>
                </c:pt>
                <c:pt idx="44">
                  <c:v>42196</c:v>
                </c:pt>
                <c:pt idx="45">
                  <c:v>42197</c:v>
                </c:pt>
                <c:pt idx="46">
                  <c:v>42198</c:v>
                </c:pt>
                <c:pt idx="47">
                  <c:v>42199</c:v>
                </c:pt>
                <c:pt idx="48">
                  <c:v>42200</c:v>
                </c:pt>
                <c:pt idx="49">
                  <c:v>42201</c:v>
                </c:pt>
                <c:pt idx="50">
                  <c:v>42202</c:v>
                </c:pt>
                <c:pt idx="51">
                  <c:v>42203</c:v>
                </c:pt>
                <c:pt idx="52">
                  <c:v>42204</c:v>
                </c:pt>
                <c:pt idx="53">
                  <c:v>42205</c:v>
                </c:pt>
                <c:pt idx="54">
                  <c:v>42206</c:v>
                </c:pt>
                <c:pt idx="55">
                  <c:v>42207</c:v>
                </c:pt>
                <c:pt idx="56">
                  <c:v>42208</c:v>
                </c:pt>
                <c:pt idx="57">
                  <c:v>42209</c:v>
                </c:pt>
                <c:pt idx="58">
                  <c:v>42210</c:v>
                </c:pt>
                <c:pt idx="59">
                  <c:v>42211</c:v>
                </c:pt>
                <c:pt idx="60">
                  <c:v>42212</c:v>
                </c:pt>
                <c:pt idx="61">
                  <c:v>42213</c:v>
                </c:pt>
                <c:pt idx="62">
                  <c:v>42214</c:v>
                </c:pt>
                <c:pt idx="63">
                  <c:v>42215</c:v>
                </c:pt>
                <c:pt idx="64">
                  <c:v>42216</c:v>
                </c:pt>
                <c:pt idx="65">
                  <c:v>42217</c:v>
                </c:pt>
                <c:pt idx="66">
                  <c:v>42218</c:v>
                </c:pt>
                <c:pt idx="67">
                  <c:v>42219</c:v>
                </c:pt>
                <c:pt idx="68">
                  <c:v>42220</c:v>
                </c:pt>
                <c:pt idx="69">
                  <c:v>42221</c:v>
                </c:pt>
                <c:pt idx="70">
                  <c:v>42222</c:v>
                </c:pt>
                <c:pt idx="71">
                  <c:v>42223</c:v>
                </c:pt>
                <c:pt idx="72">
                  <c:v>42224</c:v>
                </c:pt>
                <c:pt idx="73">
                  <c:v>42225</c:v>
                </c:pt>
                <c:pt idx="74">
                  <c:v>42226</c:v>
                </c:pt>
                <c:pt idx="75">
                  <c:v>42227</c:v>
                </c:pt>
                <c:pt idx="76">
                  <c:v>42228</c:v>
                </c:pt>
                <c:pt idx="77">
                  <c:v>42229</c:v>
                </c:pt>
                <c:pt idx="78">
                  <c:v>42230</c:v>
                </c:pt>
                <c:pt idx="79">
                  <c:v>42231</c:v>
                </c:pt>
                <c:pt idx="80">
                  <c:v>42232</c:v>
                </c:pt>
                <c:pt idx="81">
                  <c:v>42233</c:v>
                </c:pt>
                <c:pt idx="82">
                  <c:v>42234</c:v>
                </c:pt>
                <c:pt idx="83">
                  <c:v>42235</c:v>
                </c:pt>
                <c:pt idx="84">
                  <c:v>42236</c:v>
                </c:pt>
                <c:pt idx="85">
                  <c:v>42237</c:v>
                </c:pt>
                <c:pt idx="86">
                  <c:v>42238</c:v>
                </c:pt>
                <c:pt idx="87">
                  <c:v>42239</c:v>
                </c:pt>
                <c:pt idx="88">
                  <c:v>42240</c:v>
                </c:pt>
                <c:pt idx="89">
                  <c:v>42241</c:v>
                </c:pt>
                <c:pt idx="90">
                  <c:v>42242</c:v>
                </c:pt>
                <c:pt idx="91">
                  <c:v>42243</c:v>
                </c:pt>
                <c:pt idx="92">
                  <c:v>42244</c:v>
                </c:pt>
                <c:pt idx="93">
                  <c:v>42245</c:v>
                </c:pt>
                <c:pt idx="94">
                  <c:v>42246</c:v>
                </c:pt>
                <c:pt idx="95">
                  <c:v>42247</c:v>
                </c:pt>
                <c:pt idx="96">
                  <c:v>42248</c:v>
                </c:pt>
                <c:pt idx="97">
                  <c:v>42249</c:v>
                </c:pt>
                <c:pt idx="98">
                  <c:v>42250</c:v>
                </c:pt>
                <c:pt idx="99">
                  <c:v>42251</c:v>
                </c:pt>
                <c:pt idx="100">
                  <c:v>42252</c:v>
                </c:pt>
                <c:pt idx="101">
                  <c:v>42253</c:v>
                </c:pt>
                <c:pt idx="102">
                  <c:v>42254</c:v>
                </c:pt>
                <c:pt idx="103">
                  <c:v>42255</c:v>
                </c:pt>
                <c:pt idx="104">
                  <c:v>42256</c:v>
                </c:pt>
                <c:pt idx="105">
                  <c:v>42257</c:v>
                </c:pt>
                <c:pt idx="106">
                  <c:v>42258</c:v>
                </c:pt>
                <c:pt idx="107">
                  <c:v>42259</c:v>
                </c:pt>
                <c:pt idx="108">
                  <c:v>42260</c:v>
                </c:pt>
                <c:pt idx="109">
                  <c:v>42261</c:v>
                </c:pt>
                <c:pt idx="110">
                  <c:v>42262</c:v>
                </c:pt>
                <c:pt idx="111">
                  <c:v>42263</c:v>
                </c:pt>
                <c:pt idx="112">
                  <c:v>42264</c:v>
                </c:pt>
                <c:pt idx="113">
                  <c:v>42265</c:v>
                </c:pt>
                <c:pt idx="114">
                  <c:v>42266</c:v>
                </c:pt>
                <c:pt idx="115">
                  <c:v>42267</c:v>
                </c:pt>
                <c:pt idx="116">
                  <c:v>42268</c:v>
                </c:pt>
                <c:pt idx="117">
                  <c:v>42269</c:v>
                </c:pt>
                <c:pt idx="118">
                  <c:v>42270</c:v>
                </c:pt>
                <c:pt idx="119">
                  <c:v>42271</c:v>
                </c:pt>
                <c:pt idx="120">
                  <c:v>42272</c:v>
                </c:pt>
                <c:pt idx="121">
                  <c:v>42273</c:v>
                </c:pt>
                <c:pt idx="122">
                  <c:v>42274</c:v>
                </c:pt>
                <c:pt idx="123">
                  <c:v>42275</c:v>
                </c:pt>
                <c:pt idx="124">
                  <c:v>42276</c:v>
                </c:pt>
                <c:pt idx="125">
                  <c:v>42277</c:v>
                </c:pt>
              </c:numCache>
            </c:numRef>
          </c:cat>
          <c:val>
            <c:numRef>
              <c:f>'2015'!$E$29:$E$154</c:f>
              <c:numCache>
                <c:formatCode>General</c:formatCode>
                <c:ptCount val="126"/>
                <c:pt idx="0">
                  <c:v>17.899999999999999</c:v>
                </c:pt>
                <c:pt idx="1">
                  <c:v>23.5</c:v>
                </c:pt>
                <c:pt idx="2">
                  <c:v>27.5</c:v>
                </c:pt>
                <c:pt idx="3">
                  <c:v>23.9</c:v>
                </c:pt>
                <c:pt idx="4">
                  <c:v>23.1</c:v>
                </c:pt>
                <c:pt idx="5">
                  <c:v>26.2</c:v>
                </c:pt>
                <c:pt idx="6">
                  <c:v>20.6</c:v>
                </c:pt>
                <c:pt idx="7">
                  <c:v>20.3</c:v>
                </c:pt>
                <c:pt idx="8">
                  <c:v>23.2</c:v>
                </c:pt>
                <c:pt idx="9">
                  <c:v>18.600000000000001</c:v>
                </c:pt>
                <c:pt idx="10">
                  <c:v>22.4</c:v>
                </c:pt>
                <c:pt idx="11">
                  <c:v>22.4</c:v>
                </c:pt>
                <c:pt idx="12">
                  <c:v>19.399999999999999</c:v>
                </c:pt>
                <c:pt idx="13">
                  <c:v>25.6</c:v>
                </c:pt>
                <c:pt idx="14">
                  <c:v>26.1</c:v>
                </c:pt>
                <c:pt idx="15">
                  <c:v>21</c:v>
                </c:pt>
                <c:pt idx="16">
                  <c:v>25.6</c:v>
                </c:pt>
                <c:pt idx="17">
                  <c:v>23.9</c:v>
                </c:pt>
                <c:pt idx="18">
                  <c:v>28.7</c:v>
                </c:pt>
                <c:pt idx="19">
                  <c:v>24.7</c:v>
                </c:pt>
                <c:pt idx="20">
                  <c:v>23.3</c:v>
                </c:pt>
                <c:pt idx="21">
                  <c:v>22.6</c:v>
                </c:pt>
                <c:pt idx="22">
                  <c:v>21.2</c:v>
                </c:pt>
                <c:pt idx="23">
                  <c:v>24.4</c:v>
                </c:pt>
                <c:pt idx="24">
                  <c:v>25</c:v>
                </c:pt>
                <c:pt idx="25">
                  <c:v>24.3</c:v>
                </c:pt>
                <c:pt idx="26">
                  <c:v>24</c:v>
                </c:pt>
                <c:pt idx="27">
                  <c:v>25.8</c:v>
                </c:pt>
                <c:pt idx="28">
                  <c:v>24.8</c:v>
                </c:pt>
                <c:pt idx="29">
                  <c:v>24.5</c:v>
                </c:pt>
                <c:pt idx="30">
                  <c:v>21.1</c:v>
                </c:pt>
                <c:pt idx="31">
                  <c:v>19.7</c:v>
                </c:pt>
                <c:pt idx="32">
                  <c:v>21.5</c:v>
                </c:pt>
                <c:pt idx="33">
                  <c:v>21.8</c:v>
                </c:pt>
                <c:pt idx="34">
                  <c:v>19.8</c:v>
                </c:pt>
                <c:pt idx="35">
                  <c:v>26.2</c:v>
                </c:pt>
                <c:pt idx="36">
                  <c:v>24.5</c:v>
                </c:pt>
                <c:pt idx="37">
                  <c:v>23.5</c:v>
                </c:pt>
                <c:pt idx="38">
                  <c:v>22.4</c:v>
                </c:pt>
                <c:pt idx="39">
                  <c:v>22.1</c:v>
                </c:pt>
                <c:pt idx="40">
                  <c:v>26.1</c:v>
                </c:pt>
                <c:pt idx="41">
                  <c:v>23.8</c:v>
                </c:pt>
                <c:pt idx="42">
                  <c:v>23</c:v>
                </c:pt>
                <c:pt idx="43">
                  <c:v>26.2</c:v>
                </c:pt>
                <c:pt idx="44">
                  <c:v>31.3</c:v>
                </c:pt>
                <c:pt idx="45">
                  <c:v>32</c:v>
                </c:pt>
                <c:pt idx="46">
                  <c:v>29.2</c:v>
                </c:pt>
                <c:pt idx="47">
                  <c:v>33.200000000000003</c:v>
                </c:pt>
                <c:pt idx="48">
                  <c:v>32.9</c:v>
                </c:pt>
                <c:pt idx="49">
                  <c:v>24</c:v>
                </c:pt>
                <c:pt idx="50">
                  <c:v>27.3</c:v>
                </c:pt>
                <c:pt idx="51">
                  <c:v>28.5</c:v>
                </c:pt>
                <c:pt idx="52">
                  <c:v>30</c:v>
                </c:pt>
                <c:pt idx="53">
                  <c:v>28.1</c:v>
                </c:pt>
                <c:pt idx="54">
                  <c:v>29.4</c:v>
                </c:pt>
                <c:pt idx="55">
                  <c:v>32.200000000000003</c:v>
                </c:pt>
                <c:pt idx="56">
                  <c:v>27.8</c:v>
                </c:pt>
                <c:pt idx="57">
                  <c:v>29.5</c:v>
                </c:pt>
                <c:pt idx="58">
                  <c:v>29.9</c:v>
                </c:pt>
                <c:pt idx="59">
                  <c:v>32</c:v>
                </c:pt>
                <c:pt idx="60">
                  <c:v>33.6</c:v>
                </c:pt>
                <c:pt idx="61">
                  <c:v>30.8</c:v>
                </c:pt>
                <c:pt idx="62">
                  <c:v>32.1</c:v>
                </c:pt>
                <c:pt idx="63">
                  <c:v>30</c:v>
                </c:pt>
                <c:pt idx="64">
                  <c:v>33</c:v>
                </c:pt>
                <c:pt idx="65">
                  <c:v>33.300000000000004</c:v>
                </c:pt>
                <c:pt idx="66">
                  <c:v>32.300000000000004</c:v>
                </c:pt>
                <c:pt idx="67">
                  <c:v>32.800000000000004</c:v>
                </c:pt>
                <c:pt idx="68">
                  <c:v>34.1</c:v>
                </c:pt>
                <c:pt idx="69">
                  <c:v>35.800000000000004</c:v>
                </c:pt>
                <c:pt idx="70">
                  <c:v>35.800000000000004</c:v>
                </c:pt>
                <c:pt idx="71">
                  <c:v>34.5</c:v>
                </c:pt>
                <c:pt idx="72">
                  <c:v>27.4</c:v>
                </c:pt>
                <c:pt idx="73">
                  <c:v>27.9</c:v>
                </c:pt>
                <c:pt idx="74">
                  <c:v>29.7</c:v>
                </c:pt>
                <c:pt idx="75">
                  <c:v>29</c:v>
                </c:pt>
                <c:pt idx="76">
                  <c:v>28.9</c:v>
                </c:pt>
                <c:pt idx="77">
                  <c:v>23.6</c:v>
                </c:pt>
                <c:pt idx="78">
                  <c:v>25.4</c:v>
                </c:pt>
                <c:pt idx="79">
                  <c:v>29.7</c:v>
                </c:pt>
                <c:pt idx="80">
                  <c:v>27.9</c:v>
                </c:pt>
                <c:pt idx="81">
                  <c:v>25.6</c:v>
                </c:pt>
                <c:pt idx="82">
                  <c:v>31.3</c:v>
                </c:pt>
                <c:pt idx="83">
                  <c:v>27.8</c:v>
                </c:pt>
                <c:pt idx="84">
                  <c:v>26.2</c:v>
                </c:pt>
                <c:pt idx="85">
                  <c:v>25.2</c:v>
                </c:pt>
                <c:pt idx="86">
                  <c:v>27.9</c:v>
                </c:pt>
                <c:pt idx="87">
                  <c:v>22.6</c:v>
                </c:pt>
                <c:pt idx="88">
                  <c:v>23.4</c:v>
                </c:pt>
                <c:pt idx="89">
                  <c:v>21.5</c:v>
                </c:pt>
                <c:pt idx="90">
                  <c:v>21.7</c:v>
                </c:pt>
                <c:pt idx="91">
                  <c:v>20.7</c:v>
                </c:pt>
                <c:pt idx="92">
                  <c:v>23.4</c:v>
                </c:pt>
                <c:pt idx="93">
                  <c:v>19.600000000000001</c:v>
                </c:pt>
                <c:pt idx="94">
                  <c:v>20.100000000000001</c:v>
                </c:pt>
                <c:pt idx="95">
                  <c:v>21.2</c:v>
                </c:pt>
                <c:pt idx="96">
                  <c:v>24.7</c:v>
                </c:pt>
                <c:pt idx="97">
                  <c:v>31.6</c:v>
                </c:pt>
                <c:pt idx="98">
                  <c:v>26.3</c:v>
                </c:pt>
                <c:pt idx="99">
                  <c:v>27.7</c:v>
                </c:pt>
                <c:pt idx="100">
                  <c:v>26.8</c:v>
                </c:pt>
                <c:pt idx="101">
                  <c:v>22.5</c:v>
                </c:pt>
                <c:pt idx="102">
                  <c:v>21.9</c:v>
                </c:pt>
                <c:pt idx="103">
                  <c:v>19.7</c:v>
                </c:pt>
                <c:pt idx="104">
                  <c:v>22.6</c:v>
                </c:pt>
                <c:pt idx="105">
                  <c:v>23.7</c:v>
                </c:pt>
                <c:pt idx="106">
                  <c:v>24.5</c:v>
                </c:pt>
                <c:pt idx="107">
                  <c:v>26</c:v>
                </c:pt>
                <c:pt idx="108">
                  <c:v>25.5</c:v>
                </c:pt>
                <c:pt idx="109">
                  <c:v>24.2</c:v>
                </c:pt>
                <c:pt idx="110">
                  <c:v>24</c:v>
                </c:pt>
                <c:pt idx="111">
                  <c:v>23.8</c:v>
                </c:pt>
                <c:pt idx="112">
                  <c:v>22.5</c:v>
                </c:pt>
                <c:pt idx="113">
                  <c:v>21.5</c:v>
                </c:pt>
                <c:pt idx="114">
                  <c:v>26.9</c:v>
                </c:pt>
                <c:pt idx="115">
                  <c:v>25.7</c:v>
                </c:pt>
                <c:pt idx="116">
                  <c:v>25</c:v>
                </c:pt>
                <c:pt idx="117">
                  <c:v>26.4</c:v>
                </c:pt>
                <c:pt idx="118">
                  <c:v>24.9</c:v>
                </c:pt>
                <c:pt idx="119">
                  <c:v>22.4</c:v>
                </c:pt>
                <c:pt idx="120">
                  <c:v>19</c:v>
                </c:pt>
                <c:pt idx="121">
                  <c:v>20.399999999999999</c:v>
                </c:pt>
                <c:pt idx="122">
                  <c:v>26.1</c:v>
                </c:pt>
                <c:pt idx="123">
                  <c:v>25.4</c:v>
                </c:pt>
                <c:pt idx="124">
                  <c:v>20.9</c:v>
                </c:pt>
                <c:pt idx="125">
                  <c:v>21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AC4-4C9D-98D0-AF7FF4CB0686}"/>
            </c:ext>
          </c:extLst>
        </c:ser>
        <c:ser>
          <c:idx val="0"/>
          <c:order val="1"/>
          <c:tx>
            <c:strRef>
              <c:f>'2015'!$D$1</c:f>
              <c:strCache>
                <c:ptCount val="1"/>
                <c:pt idx="0">
                  <c:v>平均気温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none"/>
          </c:marker>
          <c:cat>
            <c:numRef>
              <c:f>'2015'!$B$29:$B$154</c:f>
              <c:numCache>
                <c:formatCode>mm"月"dd"日"</c:formatCode>
                <c:ptCount val="126"/>
                <c:pt idx="0">
                  <c:v>42152</c:v>
                </c:pt>
                <c:pt idx="1">
                  <c:v>42153</c:v>
                </c:pt>
                <c:pt idx="2">
                  <c:v>42154</c:v>
                </c:pt>
                <c:pt idx="3">
                  <c:v>42155</c:v>
                </c:pt>
                <c:pt idx="4">
                  <c:v>42156</c:v>
                </c:pt>
                <c:pt idx="5">
                  <c:v>42157</c:v>
                </c:pt>
                <c:pt idx="6">
                  <c:v>42158</c:v>
                </c:pt>
                <c:pt idx="7">
                  <c:v>42159</c:v>
                </c:pt>
                <c:pt idx="8">
                  <c:v>42160</c:v>
                </c:pt>
                <c:pt idx="9">
                  <c:v>42161</c:v>
                </c:pt>
                <c:pt idx="10">
                  <c:v>42162</c:v>
                </c:pt>
                <c:pt idx="11">
                  <c:v>42163</c:v>
                </c:pt>
                <c:pt idx="12">
                  <c:v>42164</c:v>
                </c:pt>
                <c:pt idx="13">
                  <c:v>42165</c:v>
                </c:pt>
                <c:pt idx="14">
                  <c:v>42166</c:v>
                </c:pt>
                <c:pt idx="15">
                  <c:v>42167</c:v>
                </c:pt>
                <c:pt idx="16">
                  <c:v>42168</c:v>
                </c:pt>
                <c:pt idx="17">
                  <c:v>42169</c:v>
                </c:pt>
                <c:pt idx="18">
                  <c:v>42170</c:v>
                </c:pt>
                <c:pt idx="19">
                  <c:v>42171</c:v>
                </c:pt>
                <c:pt idx="20">
                  <c:v>42172</c:v>
                </c:pt>
                <c:pt idx="21">
                  <c:v>42173</c:v>
                </c:pt>
                <c:pt idx="22">
                  <c:v>42174</c:v>
                </c:pt>
                <c:pt idx="23">
                  <c:v>42175</c:v>
                </c:pt>
                <c:pt idx="24">
                  <c:v>42176</c:v>
                </c:pt>
                <c:pt idx="25">
                  <c:v>42177</c:v>
                </c:pt>
                <c:pt idx="26">
                  <c:v>42178</c:v>
                </c:pt>
                <c:pt idx="27">
                  <c:v>42179</c:v>
                </c:pt>
                <c:pt idx="28">
                  <c:v>42180</c:v>
                </c:pt>
                <c:pt idx="29">
                  <c:v>42181</c:v>
                </c:pt>
                <c:pt idx="30">
                  <c:v>42182</c:v>
                </c:pt>
                <c:pt idx="31">
                  <c:v>42183</c:v>
                </c:pt>
                <c:pt idx="32">
                  <c:v>42184</c:v>
                </c:pt>
                <c:pt idx="33">
                  <c:v>42185</c:v>
                </c:pt>
                <c:pt idx="34">
                  <c:v>42186</c:v>
                </c:pt>
                <c:pt idx="35">
                  <c:v>42187</c:v>
                </c:pt>
                <c:pt idx="36">
                  <c:v>42188</c:v>
                </c:pt>
                <c:pt idx="37">
                  <c:v>42189</c:v>
                </c:pt>
                <c:pt idx="38">
                  <c:v>42190</c:v>
                </c:pt>
                <c:pt idx="39">
                  <c:v>42191</c:v>
                </c:pt>
                <c:pt idx="40">
                  <c:v>42192</c:v>
                </c:pt>
                <c:pt idx="41">
                  <c:v>42193</c:v>
                </c:pt>
                <c:pt idx="42">
                  <c:v>42194</c:v>
                </c:pt>
                <c:pt idx="43">
                  <c:v>42195</c:v>
                </c:pt>
                <c:pt idx="44">
                  <c:v>42196</c:v>
                </c:pt>
                <c:pt idx="45">
                  <c:v>42197</c:v>
                </c:pt>
                <c:pt idx="46">
                  <c:v>42198</c:v>
                </c:pt>
                <c:pt idx="47">
                  <c:v>42199</c:v>
                </c:pt>
                <c:pt idx="48">
                  <c:v>42200</c:v>
                </c:pt>
                <c:pt idx="49">
                  <c:v>42201</c:v>
                </c:pt>
                <c:pt idx="50">
                  <c:v>42202</c:v>
                </c:pt>
                <c:pt idx="51">
                  <c:v>42203</c:v>
                </c:pt>
                <c:pt idx="52">
                  <c:v>42204</c:v>
                </c:pt>
                <c:pt idx="53">
                  <c:v>42205</c:v>
                </c:pt>
                <c:pt idx="54">
                  <c:v>42206</c:v>
                </c:pt>
                <c:pt idx="55">
                  <c:v>42207</c:v>
                </c:pt>
                <c:pt idx="56">
                  <c:v>42208</c:v>
                </c:pt>
                <c:pt idx="57">
                  <c:v>42209</c:v>
                </c:pt>
                <c:pt idx="58">
                  <c:v>42210</c:v>
                </c:pt>
                <c:pt idx="59">
                  <c:v>42211</c:v>
                </c:pt>
                <c:pt idx="60">
                  <c:v>42212</c:v>
                </c:pt>
                <c:pt idx="61">
                  <c:v>42213</c:v>
                </c:pt>
                <c:pt idx="62">
                  <c:v>42214</c:v>
                </c:pt>
                <c:pt idx="63">
                  <c:v>42215</c:v>
                </c:pt>
                <c:pt idx="64">
                  <c:v>42216</c:v>
                </c:pt>
                <c:pt idx="65">
                  <c:v>42217</c:v>
                </c:pt>
                <c:pt idx="66">
                  <c:v>42218</c:v>
                </c:pt>
                <c:pt idx="67">
                  <c:v>42219</c:v>
                </c:pt>
                <c:pt idx="68">
                  <c:v>42220</c:v>
                </c:pt>
                <c:pt idx="69">
                  <c:v>42221</c:v>
                </c:pt>
                <c:pt idx="70">
                  <c:v>42222</c:v>
                </c:pt>
                <c:pt idx="71">
                  <c:v>42223</c:v>
                </c:pt>
                <c:pt idx="72">
                  <c:v>42224</c:v>
                </c:pt>
                <c:pt idx="73">
                  <c:v>42225</c:v>
                </c:pt>
                <c:pt idx="74">
                  <c:v>42226</c:v>
                </c:pt>
                <c:pt idx="75">
                  <c:v>42227</c:v>
                </c:pt>
                <c:pt idx="76">
                  <c:v>42228</c:v>
                </c:pt>
                <c:pt idx="77">
                  <c:v>42229</c:v>
                </c:pt>
                <c:pt idx="78">
                  <c:v>42230</c:v>
                </c:pt>
                <c:pt idx="79">
                  <c:v>42231</c:v>
                </c:pt>
                <c:pt idx="80">
                  <c:v>42232</c:v>
                </c:pt>
                <c:pt idx="81">
                  <c:v>42233</c:v>
                </c:pt>
                <c:pt idx="82">
                  <c:v>42234</c:v>
                </c:pt>
                <c:pt idx="83">
                  <c:v>42235</c:v>
                </c:pt>
                <c:pt idx="84">
                  <c:v>42236</c:v>
                </c:pt>
                <c:pt idx="85">
                  <c:v>42237</c:v>
                </c:pt>
                <c:pt idx="86">
                  <c:v>42238</c:v>
                </c:pt>
                <c:pt idx="87">
                  <c:v>42239</c:v>
                </c:pt>
                <c:pt idx="88">
                  <c:v>42240</c:v>
                </c:pt>
                <c:pt idx="89">
                  <c:v>42241</c:v>
                </c:pt>
                <c:pt idx="90">
                  <c:v>42242</c:v>
                </c:pt>
                <c:pt idx="91">
                  <c:v>42243</c:v>
                </c:pt>
                <c:pt idx="92">
                  <c:v>42244</c:v>
                </c:pt>
                <c:pt idx="93">
                  <c:v>42245</c:v>
                </c:pt>
                <c:pt idx="94">
                  <c:v>42246</c:v>
                </c:pt>
                <c:pt idx="95">
                  <c:v>42247</c:v>
                </c:pt>
                <c:pt idx="96">
                  <c:v>42248</c:v>
                </c:pt>
                <c:pt idx="97">
                  <c:v>42249</c:v>
                </c:pt>
                <c:pt idx="98">
                  <c:v>42250</c:v>
                </c:pt>
                <c:pt idx="99">
                  <c:v>42251</c:v>
                </c:pt>
                <c:pt idx="100">
                  <c:v>42252</c:v>
                </c:pt>
                <c:pt idx="101">
                  <c:v>42253</c:v>
                </c:pt>
                <c:pt idx="102">
                  <c:v>42254</c:v>
                </c:pt>
                <c:pt idx="103">
                  <c:v>42255</c:v>
                </c:pt>
                <c:pt idx="104">
                  <c:v>42256</c:v>
                </c:pt>
                <c:pt idx="105">
                  <c:v>42257</c:v>
                </c:pt>
                <c:pt idx="106">
                  <c:v>42258</c:v>
                </c:pt>
                <c:pt idx="107">
                  <c:v>42259</c:v>
                </c:pt>
                <c:pt idx="108">
                  <c:v>42260</c:v>
                </c:pt>
                <c:pt idx="109">
                  <c:v>42261</c:v>
                </c:pt>
                <c:pt idx="110">
                  <c:v>42262</c:v>
                </c:pt>
                <c:pt idx="111">
                  <c:v>42263</c:v>
                </c:pt>
                <c:pt idx="112">
                  <c:v>42264</c:v>
                </c:pt>
                <c:pt idx="113">
                  <c:v>42265</c:v>
                </c:pt>
                <c:pt idx="114">
                  <c:v>42266</c:v>
                </c:pt>
                <c:pt idx="115">
                  <c:v>42267</c:v>
                </c:pt>
                <c:pt idx="116">
                  <c:v>42268</c:v>
                </c:pt>
                <c:pt idx="117">
                  <c:v>42269</c:v>
                </c:pt>
                <c:pt idx="118">
                  <c:v>42270</c:v>
                </c:pt>
                <c:pt idx="119">
                  <c:v>42271</c:v>
                </c:pt>
                <c:pt idx="120">
                  <c:v>42272</c:v>
                </c:pt>
                <c:pt idx="121">
                  <c:v>42273</c:v>
                </c:pt>
                <c:pt idx="122">
                  <c:v>42274</c:v>
                </c:pt>
                <c:pt idx="123">
                  <c:v>42275</c:v>
                </c:pt>
                <c:pt idx="124">
                  <c:v>42276</c:v>
                </c:pt>
                <c:pt idx="125">
                  <c:v>42277</c:v>
                </c:pt>
              </c:numCache>
            </c:numRef>
          </c:cat>
          <c:val>
            <c:numRef>
              <c:f>'2015'!$D$29:$D$154</c:f>
              <c:numCache>
                <c:formatCode>General</c:formatCode>
                <c:ptCount val="126"/>
                <c:pt idx="0">
                  <c:v>15.9</c:v>
                </c:pt>
                <c:pt idx="1">
                  <c:v>19.7</c:v>
                </c:pt>
                <c:pt idx="2">
                  <c:v>21.4</c:v>
                </c:pt>
                <c:pt idx="3">
                  <c:v>19.8</c:v>
                </c:pt>
                <c:pt idx="4">
                  <c:v>17</c:v>
                </c:pt>
                <c:pt idx="5">
                  <c:v>18.8</c:v>
                </c:pt>
                <c:pt idx="6">
                  <c:v>18</c:v>
                </c:pt>
                <c:pt idx="7">
                  <c:v>16.8</c:v>
                </c:pt>
                <c:pt idx="8">
                  <c:v>17.3</c:v>
                </c:pt>
                <c:pt idx="9">
                  <c:v>14.2</c:v>
                </c:pt>
                <c:pt idx="10">
                  <c:v>16.5</c:v>
                </c:pt>
                <c:pt idx="11">
                  <c:v>17.899999999999999</c:v>
                </c:pt>
                <c:pt idx="12">
                  <c:v>17.600000000000001</c:v>
                </c:pt>
                <c:pt idx="13">
                  <c:v>21.2</c:v>
                </c:pt>
                <c:pt idx="14">
                  <c:v>19.600000000000001</c:v>
                </c:pt>
                <c:pt idx="15">
                  <c:v>19.399999999999999</c:v>
                </c:pt>
                <c:pt idx="16">
                  <c:v>20.3</c:v>
                </c:pt>
                <c:pt idx="17">
                  <c:v>20</c:v>
                </c:pt>
                <c:pt idx="18">
                  <c:v>21.1</c:v>
                </c:pt>
                <c:pt idx="19">
                  <c:v>19.7</c:v>
                </c:pt>
                <c:pt idx="20">
                  <c:v>20.5</c:v>
                </c:pt>
                <c:pt idx="21">
                  <c:v>19.600000000000001</c:v>
                </c:pt>
                <c:pt idx="22">
                  <c:v>18.7</c:v>
                </c:pt>
                <c:pt idx="23">
                  <c:v>19.8</c:v>
                </c:pt>
                <c:pt idx="24">
                  <c:v>19.899999999999999</c:v>
                </c:pt>
                <c:pt idx="25">
                  <c:v>20.6</c:v>
                </c:pt>
                <c:pt idx="26">
                  <c:v>20.8</c:v>
                </c:pt>
                <c:pt idx="27">
                  <c:v>21.2</c:v>
                </c:pt>
                <c:pt idx="28">
                  <c:v>21.3</c:v>
                </c:pt>
                <c:pt idx="29">
                  <c:v>21.8</c:v>
                </c:pt>
                <c:pt idx="30">
                  <c:v>20</c:v>
                </c:pt>
                <c:pt idx="31">
                  <c:v>16.3</c:v>
                </c:pt>
                <c:pt idx="32">
                  <c:v>17.2</c:v>
                </c:pt>
                <c:pt idx="33">
                  <c:v>19.8</c:v>
                </c:pt>
                <c:pt idx="34">
                  <c:v>18.899999999999999</c:v>
                </c:pt>
                <c:pt idx="35">
                  <c:v>22</c:v>
                </c:pt>
                <c:pt idx="36">
                  <c:v>21.6</c:v>
                </c:pt>
                <c:pt idx="37">
                  <c:v>20.100000000000001</c:v>
                </c:pt>
                <c:pt idx="38">
                  <c:v>20</c:v>
                </c:pt>
                <c:pt idx="39">
                  <c:v>20.100000000000001</c:v>
                </c:pt>
                <c:pt idx="40">
                  <c:v>21.7</c:v>
                </c:pt>
                <c:pt idx="41">
                  <c:v>19.399999999999999</c:v>
                </c:pt>
                <c:pt idx="42">
                  <c:v>19.600000000000001</c:v>
                </c:pt>
                <c:pt idx="43">
                  <c:v>21.6</c:v>
                </c:pt>
                <c:pt idx="44">
                  <c:v>23.5</c:v>
                </c:pt>
                <c:pt idx="45">
                  <c:v>23.3</c:v>
                </c:pt>
                <c:pt idx="46">
                  <c:v>23.2</c:v>
                </c:pt>
                <c:pt idx="47">
                  <c:v>26.8</c:v>
                </c:pt>
                <c:pt idx="48">
                  <c:v>26.1</c:v>
                </c:pt>
                <c:pt idx="49">
                  <c:v>21.7</c:v>
                </c:pt>
                <c:pt idx="50">
                  <c:v>24</c:v>
                </c:pt>
                <c:pt idx="51">
                  <c:v>24.6</c:v>
                </c:pt>
                <c:pt idx="52">
                  <c:v>25.9</c:v>
                </c:pt>
                <c:pt idx="53">
                  <c:v>24.3</c:v>
                </c:pt>
                <c:pt idx="54">
                  <c:v>25.1</c:v>
                </c:pt>
                <c:pt idx="55">
                  <c:v>26.1</c:v>
                </c:pt>
                <c:pt idx="56">
                  <c:v>25.2</c:v>
                </c:pt>
                <c:pt idx="57">
                  <c:v>25.7</c:v>
                </c:pt>
                <c:pt idx="58">
                  <c:v>25.7</c:v>
                </c:pt>
                <c:pt idx="59">
                  <c:v>27</c:v>
                </c:pt>
                <c:pt idx="60">
                  <c:v>26.5</c:v>
                </c:pt>
                <c:pt idx="61">
                  <c:v>26.6</c:v>
                </c:pt>
                <c:pt idx="62">
                  <c:v>26.5</c:v>
                </c:pt>
                <c:pt idx="63">
                  <c:v>25.8</c:v>
                </c:pt>
                <c:pt idx="64">
                  <c:v>27.3</c:v>
                </c:pt>
                <c:pt idx="65">
                  <c:v>27.7</c:v>
                </c:pt>
                <c:pt idx="66">
                  <c:v>26.3</c:v>
                </c:pt>
                <c:pt idx="67">
                  <c:v>26.6</c:v>
                </c:pt>
                <c:pt idx="68">
                  <c:v>27.5</c:v>
                </c:pt>
                <c:pt idx="69">
                  <c:v>28.3</c:v>
                </c:pt>
                <c:pt idx="70">
                  <c:v>29</c:v>
                </c:pt>
                <c:pt idx="71">
                  <c:v>27.3</c:v>
                </c:pt>
                <c:pt idx="72">
                  <c:v>24</c:v>
                </c:pt>
                <c:pt idx="73">
                  <c:v>23.8</c:v>
                </c:pt>
                <c:pt idx="74">
                  <c:v>26</c:v>
                </c:pt>
                <c:pt idx="75">
                  <c:v>25.4</c:v>
                </c:pt>
                <c:pt idx="76">
                  <c:v>24.3</c:v>
                </c:pt>
                <c:pt idx="77">
                  <c:v>22.2</c:v>
                </c:pt>
                <c:pt idx="78">
                  <c:v>22.4</c:v>
                </c:pt>
                <c:pt idx="79">
                  <c:v>24.3</c:v>
                </c:pt>
                <c:pt idx="80">
                  <c:v>24.2</c:v>
                </c:pt>
                <c:pt idx="81">
                  <c:v>23.6</c:v>
                </c:pt>
                <c:pt idx="82">
                  <c:v>25.2</c:v>
                </c:pt>
                <c:pt idx="83">
                  <c:v>23.6</c:v>
                </c:pt>
                <c:pt idx="84">
                  <c:v>21.2</c:v>
                </c:pt>
                <c:pt idx="85">
                  <c:v>22.5</c:v>
                </c:pt>
                <c:pt idx="86">
                  <c:v>23.2</c:v>
                </c:pt>
                <c:pt idx="87">
                  <c:v>21.2</c:v>
                </c:pt>
                <c:pt idx="88">
                  <c:v>19.7</c:v>
                </c:pt>
                <c:pt idx="89">
                  <c:v>18</c:v>
                </c:pt>
                <c:pt idx="90">
                  <c:v>18.7</c:v>
                </c:pt>
                <c:pt idx="91">
                  <c:v>18.8</c:v>
                </c:pt>
                <c:pt idx="92">
                  <c:v>20.100000000000001</c:v>
                </c:pt>
                <c:pt idx="93">
                  <c:v>18.899999999999999</c:v>
                </c:pt>
                <c:pt idx="94">
                  <c:v>18.899999999999999</c:v>
                </c:pt>
                <c:pt idx="95">
                  <c:v>19.600000000000001</c:v>
                </c:pt>
                <c:pt idx="96">
                  <c:v>21.4</c:v>
                </c:pt>
                <c:pt idx="97">
                  <c:v>24.4</c:v>
                </c:pt>
                <c:pt idx="98">
                  <c:v>22.1</c:v>
                </c:pt>
                <c:pt idx="99">
                  <c:v>22.1</c:v>
                </c:pt>
                <c:pt idx="100">
                  <c:v>21.3</c:v>
                </c:pt>
                <c:pt idx="101">
                  <c:v>19.899999999999999</c:v>
                </c:pt>
                <c:pt idx="102">
                  <c:v>19.399999999999999</c:v>
                </c:pt>
                <c:pt idx="103">
                  <c:v>18.399999999999999</c:v>
                </c:pt>
                <c:pt idx="104">
                  <c:v>20.399999999999999</c:v>
                </c:pt>
                <c:pt idx="105">
                  <c:v>22.2</c:v>
                </c:pt>
                <c:pt idx="106">
                  <c:v>21.1</c:v>
                </c:pt>
                <c:pt idx="107">
                  <c:v>20.6</c:v>
                </c:pt>
                <c:pt idx="108">
                  <c:v>20.399999999999999</c:v>
                </c:pt>
                <c:pt idx="109">
                  <c:v>18.3</c:v>
                </c:pt>
                <c:pt idx="110">
                  <c:v>17.5</c:v>
                </c:pt>
                <c:pt idx="111">
                  <c:v>17.8</c:v>
                </c:pt>
                <c:pt idx="112">
                  <c:v>17.3</c:v>
                </c:pt>
                <c:pt idx="113">
                  <c:v>18.100000000000001</c:v>
                </c:pt>
                <c:pt idx="114">
                  <c:v>20.5</c:v>
                </c:pt>
                <c:pt idx="115">
                  <c:v>20.399999999999999</c:v>
                </c:pt>
                <c:pt idx="116">
                  <c:v>18</c:v>
                </c:pt>
                <c:pt idx="117">
                  <c:v>19</c:v>
                </c:pt>
                <c:pt idx="118">
                  <c:v>17.3</c:v>
                </c:pt>
                <c:pt idx="119">
                  <c:v>17.100000000000001</c:v>
                </c:pt>
                <c:pt idx="120">
                  <c:v>17.100000000000001</c:v>
                </c:pt>
                <c:pt idx="121">
                  <c:v>17.7</c:v>
                </c:pt>
                <c:pt idx="122">
                  <c:v>19.600000000000001</c:v>
                </c:pt>
                <c:pt idx="123">
                  <c:v>18.399999999999999</c:v>
                </c:pt>
                <c:pt idx="124">
                  <c:v>16.899999999999999</c:v>
                </c:pt>
                <c:pt idx="125">
                  <c:v>15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AC4-4C9D-98D0-AF7FF4CB0686}"/>
            </c:ext>
          </c:extLst>
        </c:ser>
        <c:ser>
          <c:idx val="4"/>
          <c:order val="2"/>
          <c:spPr>
            <a:ln w="19050">
              <a:solidFill>
                <a:schemeClr val="bg1">
                  <a:lumMod val="50000"/>
                </a:schemeClr>
              </a:solidFill>
            </a:ln>
          </c:spPr>
          <c:marker>
            <c:symbol val="none"/>
          </c:marker>
          <c:cat>
            <c:numRef>
              <c:f>'2015'!$B$29:$B$154</c:f>
              <c:numCache>
                <c:formatCode>mm"月"dd"日"</c:formatCode>
                <c:ptCount val="126"/>
                <c:pt idx="0">
                  <c:v>42152</c:v>
                </c:pt>
                <c:pt idx="1">
                  <c:v>42153</c:v>
                </c:pt>
                <c:pt idx="2">
                  <c:v>42154</c:v>
                </c:pt>
                <c:pt idx="3">
                  <c:v>42155</c:v>
                </c:pt>
                <c:pt idx="4">
                  <c:v>42156</c:v>
                </c:pt>
                <c:pt idx="5">
                  <c:v>42157</c:v>
                </c:pt>
                <c:pt idx="6">
                  <c:v>42158</c:v>
                </c:pt>
                <c:pt idx="7">
                  <c:v>42159</c:v>
                </c:pt>
                <c:pt idx="8">
                  <c:v>42160</c:v>
                </c:pt>
                <c:pt idx="9">
                  <c:v>42161</c:v>
                </c:pt>
                <c:pt idx="10">
                  <c:v>42162</c:v>
                </c:pt>
                <c:pt idx="11">
                  <c:v>42163</c:v>
                </c:pt>
                <c:pt idx="12">
                  <c:v>42164</c:v>
                </c:pt>
                <c:pt idx="13">
                  <c:v>42165</c:v>
                </c:pt>
                <c:pt idx="14">
                  <c:v>42166</c:v>
                </c:pt>
                <c:pt idx="15">
                  <c:v>42167</c:v>
                </c:pt>
                <c:pt idx="16">
                  <c:v>42168</c:v>
                </c:pt>
                <c:pt idx="17">
                  <c:v>42169</c:v>
                </c:pt>
                <c:pt idx="18">
                  <c:v>42170</c:v>
                </c:pt>
                <c:pt idx="19">
                  <c:v>42171</c:v>
                </c:pt>
                <c:pt idx="20">
                  <c:v>42172</c:v>
                </c:pt>
                <c:pt idx="21">
                  <c:v>42173</c:v>
                </c:pt>
                <c:pt idx="22">
                  <c:v>42174</c:v>
                </c:pt>
                <c:pt idx="23">
                  <c:v>42175</c:v>
                </c:pt>
                <c:pt idx="24">
                  <c:v>42176</c:v>
                </c:pt>
                <c:pt idx="25">
                  <c:v>42177</c:v>
                </c:pt>
                <c:pt idx="26">
                  <c:v>42178</c:v>
                </c:pt>
                <c:pt idx="27">
                  <c:v>42179</c:v>
                </c:pt>
                <c:pt idx="28">
                  <c:v>42180</c:v>
                </c:pt>
                <c:pt idx="29">
                  <c:v>42181</c:v>
                </c:pt>
                <c:pt idx="30">
                  <c:v>42182</c:v>
                </c:pt>
                <c:pt idx="31">
                  <c:v>42183</c:v>
                </c:pt>
                <c:pt idx="32">
                  <c:v>42184</c:v>
                </c:pt>
                <c:pt idx="33">
                  <c:v>42185</c:v>
                </c:pt>
                <c:pt idx="34">
                  <c:v>42186</c:v>
                </c:pt>
                <c:pt idx="35">
                  <c:v>42187</c:v>
                </c:pt>
                <c:pt idx="36">
                  <c:v>42188</c:v>
                </c:pt>
                <c:pt idx="37">
                  <c:v>42189</c:v>
                </c:pt>
                <c:pt idx="38">
                  <c:v>42190</c:v>
                </c:pt>
                <c:pt idx="39">
                  <c:v>42191</c:v>
                </c:pt>
                <c:pt idx="40">
                  <c:v>42192</c:v>
                </c:pt>
                <c:pt idx="41">
                  <c:v>42193</c:v>
                </c:pt>
                <c:pt idx="42">
                  <c:v>42194</c:v>
                </c:pt>
                <c:pt idx="43">
                  <c:v>42195</c:v>
                </c:pt>
                <c:pt idx="44">
                  <c:v>42196</c:v>
                </c:pt>
                <c:pt idx="45">
                  <c:v>42197</c:v>
                </c:pt>
                <c:pt idx="46">
                  <c:v>42198</c:v>
                </c:pt>
                <c:pt idx="47">
                  <c:v>42199</c:v>
                </c:pt>
                <c:pt idx="48">
                  <c:v>42200</c:v>
                </c:pt>
                <c:pt idx="49">
                  <c:v>42201</c:v>
                </c:pt>
                <c:pt idx="50">
                  <c:v>42202</c:v>
                </c:pt>
                <c:pt idx="51">
                  <c:v>42203</c:v>
                </c:pt>
                <c:pt idx="52">
                  <c:v>42204</c:v>
                </c:pt>
                <c:pt idx="53">
                  <c:v>42205</c:v>
                </c:pt>
                <c:pt idx="54">
                  <c:v>42206</c:v>
                </c:pt>
                <c:pt idx="55">
                  <c:v>42207</c:v>
                </c:pt>
                <c:pt idx="56">
                  <c:v>42208</c:v>
                </c:pt>
                <c:pt idx="57">
                  <c:v>42209</c:v>
                </c:pt>
                <c:pt idx="58">
                  <c:v>42210</c:v>
                </c:pt>
                <c:pt idx="59">
                  <c:v>42211</c:v>
                </c:pt>
                <c:pt idx="60">
                  <c:v>42212</c:v>
                </c:pt>
                <c:pt idx="61">
                  <c:v>42213</c:v>
                </c:pt>
                <c:pt idx="62">
                  <c:v>42214</c:v>
                </c:pt>
                <c:pt idx="63">
                  <c:v>42215</c:v>
                </c:pt>
                <c:pt idx="64">
                  <c:v>42216</c:v>
                </c:pt>
                <c:pt idx="65">
                  <c:v>42217</c:v>
                </c:pt>
                <c:pt idx="66">
                  <c:v>42218</c:v>
                </c:pt>
                <c:pt idx="67">
                  <c:v>42219</c:v>
                </c:pt>
                <c:pt idx="68">
                  <c:v>42220</c:v>
                </c:pt>
                <c:pt idx="69">
                  <c:v>42221</c:v>
                </c:pt>
                <c:pt idx="70">
                  <c:v>42222</c:v>
                </c:pt>
                <c:pt idx="71">
                  <c:v>42223</c:v>
                </c:pt>
                <c:pt idx="72">
                  <c:v>42224</c:v>
                </c:pt>
                <c:pt idx="73">
                  <c:v>42225</c:v>
                </c:pt>
                <c:pt idx="74">
                  <c:v>42226</c:v>
                </c:pt>
                <c:pt idx="75">
                  <c:v>42227</c:v>
                </c:pt>
                <c:pt idx="76">
                  <c:v>42228</c:v>
                </c:pt>
                <c:pt idx="77">
                  <c:v>42229</c:v>
                </c:pt>
                <c:pt idx="78">
                  <c:v>42230</c:v>
                </c:pt>
                <c:pt idx="79">
                  <c:v>42231</c:v>
                </c:pt>
                <c:pt idx="80">
                  <c:v>42232</c:v>
                </c:pt>
                <c:pt idx="81">
                  <c:v>42233</c:v>
                </c:pt>
                <c:pt idx="82">
                  <c:v>42234</c:v>
                </c:pt>
                <c:pt idx="83">
                  <c:v>42235</c:v>
                </c:pt>
                <c:pt idx="84">
                  <c:v>42236</c:v>
                </c:pt>
                <c:pt idx="85">
                  <c:v>42237</c:v>
                </c:pt>
                <c:pt idx="86">
                  <c:v>42238</c:v>
                </c:pt>
                <c:pt idx="87">
                  <c:v>42239</c:v>
                </c:pt>
                <c:pt idx="88">
                  <c:v>42240</c:v>
                </c:pt>
                <c:pt idx="89">
                  <c:v>42241</c:v>
                </c:pt>
                <c:pt idx="90">
                  <c:v>42242</c:v>
                </c:pt>
                <c:pt idx="91">
                  <c:v>42243</c:v>
                </c:pt>
                <c:pt idx="92">
                  <c:v>42244</c:v>
                </c:pt>
                <c:pt idx="93">
                  <c:v>42245</c:v>
                </c:pt>
                <c:pt idx="94">
                  <c:v>42246</c:v>
                </c:pt>
                <c:pt idx="95">
                  <c:v>42247</c:v>
                </c:pt>
                <c:pt idx="96">
                  <c:v>42248</c:v>
                </c:pt>
                <c:pt idx="97">
                  <c:v>42249</c:v>
                </c:pt>
                <c:pt idx="98">
                  <c:v>42250</c:v>
                </c:pt>
                <c:pt idx="99">
                  <c:v>42251</c:v>
                </c:pt>
                <c:pt idx="100">
                  <c:v>42252</c:v>
                </c:pt>
                <c:pt idx="101">
                  <c:v>42253</c:v>
                </c:pt>
                <c:pt idx="102">
                  <c:v>42254</c:v>
                </c:pt>
                <c:pt idx="103">
                  <c:v>42255</c:v>
                </c:pt>
                <c:pt idx="104">
                  <c:v>42256</c:v>
                </c:pt>
                <c:pt idx="105">
                  <c:v>42257</c:v>
                </c:pt>
                <c:pt idx="106">
                  <c:v>42258</c:v>
                </c:pt>
                <c:pt idx="107">
                  <c:v>42259</c:v>
                </c:pt>
                <c:pt idx="108">
                  <c:v>42260</c:v>
                </c:pt>
                <c:pt idx="109">
                  <c:v>42261</c:v>
                </c:pt>
                <c:pt idx="110">
                  <c:v>42262</c:v>
                </c:pt>
                <c:pt idx="111">
                  <c:v>42263</c:v>
                </c:pt>
                <c:pt idx="112">
                  <c:v>42264</c:v>
                </c:pt>
                <c:pt idx="113">
                  <c:v>42265</c:v>
                </c:pt>
                <c:pt idx="114">
                  <c:v>42266</c:v>
                </c:pt>
                <c:pt idx="115">
                  <c:v>42267</c:v>
                </c:pt>
                <c:pt idx="116">
                  <c:v>42268</c:v>
                </c:pt>
                <c:pt idx="117">
                  <c:v>42269</c:v>
                </c:pt>
                <c:pt idx="118">
                  <c:v>42270</c:v>
                </c:pt>
                <c:pt idx="119">
                  <c:v>42271</c:v>
                </c:pt>
                <c:pt idx="120">
                  <c:v>42272</c:v>
                </c:pt>
                <c:pt idx="121">
                  <c:v>42273</c:v>
                </c:pt>
                <c:pt idx="122">
                  <c:v>42274</c:v>
                </c:pt>
                <c:pt idx="123">
                  <c:v>42275</c:v>
                </c:pt>
                <c:pt idx="124">
                  <c:v>42276</c:v>
                </c:pt>
                <c:pt idx="125">
                  <c:v>42277</c:v>
                </c:pt>
              </c:numCache>
            </c:numRef>
          </c:cat>
          <c:val>
            <c:numRef>
              <c:f>'2015'!$H$29:$H$154</c:f>
              <c:numCache>
                <c:formatCode>General</c:formatCode>
                <c:ptCount val="126"/>
                <c:pt idx="0">
                  <c:v>13</c:v>
                </c:pt>
                <c:pt idx="1">
                  <c:v>16</c:v>
                </c:pt>
                <c:pt idx="2">
                  <c:v>18.7</c:v>
                </c:pt>
                <c:pt idx="3">
                  <c:v>14.7</c:v>
                </c:pt>
                <c:pt idx="4">
                  <c:v>10.3</c:v>
                </c:pt>
                <c:pt idx="5">
                  <c:v>11.7</c:v>
                </c:pt>
                <c:pt idx="6">
                  <c:v>16.100000000000001</c:v>
                </c:pt>
                <c:pt idx="7">
                  <c:v>14.3</c:v>
                </c:pt>
                <c:pt idx="8">
                  <c:v>11.2</c:v>
                </c:pt>
                <c:pt idx="9">
                  <c:v>11.2</c:v>
                </c:pt>
                <c:pt idx="10">
                  <c:v>10.200000000000001</c:v>
                </c:pt>
                <c:pt idx="11">
                  <c:v>12.8</c:v>
                </c:pt>
                <c:pt idx="12">
                  <c:v>15.3</c:v>
                </c:pt>
                <c:pt idx="13">
                  <c:v>15.1</c:v>
                </c:pt>
                <c:pt idx="14">
                  <c:v>12.6</c:v>
                </c:pt>
                <c:pt idx="15">
                  <c:v>18</c:v>
                </c:pt>
                <c:pt idx="16">
                  <c:v>17.7</c:v>
                </c:pt>
                <c:pt idx="17">
                  <c:v>17.7</c:v>
                </c:pt>
                <c:pt idx="18">
                  <c:v>16.8</c:v>
                </c:pt>
                <c:pt idx="19">
                  <c:v>17.5</c:v>
                </c:pt>
                <c:pt idx="20">
                  <c:v>18.600000000000001</c:v>
                </c:pt>
                <c:pt idx="21">
                  <c:v>16.8</c:v>
                </c:pt>
                <c:pt idx="22">
                  <c:v>16.100000000000001</c:v>
                </c:pt>
                <c:pt idx="23">
                  <c:v>16.600000000000001</c:v>
                </c:pt>
                <c:pt idx="24">
                  <c:v>16.7</c:v>
                </c:pt>
                <c:pt idx="25">
                  <c:v>17.600000000000001</c:v>
                </c:pt>
                <c:pt idx="26">
                  <c:v>18.600000000000001</c:v>
                </c:pt>
                <c:pt idx="27">
                  <c:v>18.399999999999999</c:v>
                </c:pt>
                <c:pt idx="28">
                  <c:v>18.399999999999999</c:v>
                </c:pt>
                <c:pt idx="29">
                  <c:v>20.399999999999999</c:v>
                </c:pt>
                <c:pt idx="30">
                  <c:v>18.600000000000001</c:v>
                </c:pt>
                <c:pt idx="31">
                  <c:v>12.4</c:v>
                </c:pt>
                <c:pt idx="32">
                  <c:v>12.3</c:v>
                </c:pt>
                <c:pt idx="33">
                  <c:v>17.399999999999999</c:v>
                </c:pt>
                <c:pt idx="34">
                  <c:v>18</c:v>
                </c:pt>
                <c:pt idx="35">
                  <c:v>17.3</c:v>
                </c:pt>
                <c:pt idx="36">
                  <c:v>18.8</c:v>
                </c:pt>
                <c:pt idx="37">
                  <c:v>18.2</c:v>
                </c:pt>
                <c:pt idx="38">
                  <c:v>17.399999999999999</c:v>
                </c:pt>
                <c:pt idx="39">
                  <c:v>18</c:v>
                </c:pt>
                <c:pt idx="40">
                  <c:v>17.600000000000001</c:v>
                </c:pt>
                <c:pt idx="41">
                  <c:v>17.2</c:v>
                </c:pt>
                <c:pt idx="42">
                  <c:v>16.8</c:v>
                </c:pt>
                <c:pt idx="43">
                  <c:v>17.5</c:v>
                </c:pt>
                <c:pt idx="44">
                  <c:v>16.399999999999999</c:v>
                </c:pt>
                <c:pt idx="45">
                  <c:v>15.6</c:v>
                </c:pt>
                <c:pt idx="46">
                  <c:v>19.5</c:v>
                </c:pt>
                <c:pt idx="47">
                  <c:v>21.3</c:v>
                </c:pt>
                <c:pt idx="48">
                  <c:v>22.8</c:v>
                </c:pt>
                <c:pt idx="49">
                  <c:v>19.5</c:v>
                </c:pt>
                <c:pt idx="50">
                  <c:v>21</c:v>
                </c:pt>
                <c:pt idx="51">
                  <c:v>21.2</c:v>
                </c:pt>
                <c:pt idx="52">
                  <c:v>21.4</c:v>
                </c:pt>
                <c:pt idx="53">
                  <c:v>20.6</c:v>
                </c:pt>
                <c:pt idx="54">
                  <c:v>22.6</c:v>
                </c:pt>
                <c:pt idx="55">
                  <c:v>22.2</c:v>
                </c:pt>
                <c:pt idx="56">
                  <c:v>23.1</c:v>
                </c:pt>
                <c:pt idx="57">
                  <c:v>23.6</c:v>
                </c:pt>
                <c:pt idx="58">
                  <c:v>22.6</c:v>
                </c:pt>
                <c:pt idx="59">
                  <c:v>22.1</c:v>
                </c:pt>
                <c:pt idx="60">
                  <c:v>20.100000000000001</c:v>
                </c:pt>
                <c:pt idx="61">
                  <c:v>24</c:v>
                </c:pt>
                <c:pt idx="62">
                  <c:v>22.8</c:v>
                </c:pt>
                <c:pt idx="63">
                  <c:v>23.2</c:v>
                </c:pt>
                <c:pt idx="64">
                  <c:v>23.1</c:v>
                </c:pt>
                <c:pt idx="65">
                  <c:v>22.2</c:v>
                </c:pt>
                <c:pt idx="66">
                  <c:v>21.7</c:v>
                </c:pt>
                <c:pt idx="67">
                  <c:v>22.9</c:v>
                </c:pt>
                <c:pt idx="68">
                  <c:v>22.9</c:v>
                </c:pt>
                <c:pt idx="69">
                  <c:v>22.9</c:v>
                </c:pt>
                <c:pt idx="70">
                  <c:v>22.8</c:v>
                </c:pt>
                <c:pt idx="71">
                  <c:v>21.8</c:v>
                </c:pt>
                <c:pt idx="72">
                  <c:v>20.2</c:v>
                </c:pt>
                <c:pt idx="73">
                  <c:v>20.5</c:v>
                </c:pt>
                <c:pt idx="74">
                  <c:v>23</c:v>
                </c:pt>
                <c:pt idx="75">
                  <c:v>22.5</c:v>
                </c:pt>
                <c:pt idx="76">
                  <c:v>21.4</c:v>
                </c:pt>
                <c:pt idx="77">
                  <c:v>21</c:v>
                </c:pt>
                <c:pt idx="78">
                  <c:v>20.8</c:v>
                </c:pt>
                <c:pt idx="79">
                  <c:v>20.5</c:v>
                </c:pt>
                <c:pt idx="80">
                  <c:v>21.1</c:v>
                </c:pt>
                <c:pt idx="81">
                  <c:v>21.7</c:v>
                </c:pt>
                <c:pt idx="82">
                  <c:v>21.1</c:v>
                </c:pt>
                <c:pt idx="83">
                  <c:v>17.899999999999999</c:v>
                </c:pt>
                <c:pt idx="84">
                  <c:v>16.899999999999999</c:v>
                </c:pt>
                <c:pt idx="85">
                  <c:v>20.399999999999999</c:v>
                </c:pt>
                <c:pt idx="86">
                  <c:v>21.6</c:v>
                </c:pt>
                <c:pt idx="87">
                  <c:v>19</c:v>
                </c:pt>
                <c:pt idx="88">
                  <c:v>15.2</c:v>
                </c:pt>
                <c:pt idx="89">
                  <c:v>15.2</c:v>
                </c:pt>
                <c:pt idx="90">
                  <c:v>16.5</c:v>
                </c:pt>
                <c:pt idx="91">
                  <c:v>17.3</c:v>
                </c:pt>
                <c:pt idx="92">
                  <c:v>17.8</c:v>
                </c:pt>
                <c:pt idx="93">
                  <c:v>18.5</c:v>
                </c:pt>
                <c:pt idx="94">
                  <c:v>18.100000000000001</c:v>
                </c:pt>
                <c:pt idx="95">
                  <c:v>18.3</c:v>
                </c:pt>
                <c:pt idx="96">
                  <c:v>19.2</c:v>
                </c:pt>
                <c:pt idx="97">
                  <c:v>20.399999999999999</c:v>
                </c:pt>
                <c:pt idx="98">
                  <c:v>17.5</c:v>
                </c:pt>
                <c:pt idx="99">
                  <c:v>18.5</c:v>
                </c:pt>
                <c:pt idx="100">
                  <c:v>15.9</c:v>
                </c:pt>
                <c:pt idx="101">
                  <c:v>18.5</c:v>
                </c:pt>
                <c:pt idx="102">
                  <c:v>18.5</c:v>
                </c:pt>
                <c:pt idx="103">
                  <c:v>17.600000000000001</c:v>
                </c:pt>
                <c:pt idx="104">
                  <c:v>17.100000000000001</c:v>
                </c:pt>
                <c:pt idx="105">
                  <c:v>21.6</c:v>
                </c:pt>
                <c:pt idx="106">
                  <c:v>17.600000000000001</c:v>
                </c:pt>
                <c:pt idx="107">
                  <c:v>14.6</c:v>
                </c:pt>
                <c:pt idx="108">
                  <c:v>16.5</c:v>
                </c:pt>
                <c:pt idx="109">
                  <c:v>14.1</c:v>
                </c:pt>
                <c:pt idx="110">
                  <c:v>12</c:v>
                </c:pt>
                <c:pt idx="111">
                  <c:v>12.9</c:v>
                </c:pt>
                <c:pt idx="112">
                  <c:v>13.8</c:v>
                </c:pt>
                <c:pt idx="113">
                  <c:v>14.4</c:v>
                </c:pt>
                <c:pt idx="114">
                  <c:v>15.7</c:v>
                </c:pt>
                <c:pt idx="115">
                  <c:v>15.2</c:v>
                </c:pt>
                <c:pt idx="116">
                  <c:v>12.1</c:v>
                </c:pt>
                <c:pt idx="117">
                  <c:v>11.8</c:v>
                </c:pt>
                <c:pt idx="118">
                  <c:v>11.3</c:v>
                </c:pt>
                <c:pt idx="119">
                  <c:v>12.1</c:v>
                </c:pt>
                <c:pt idx="120">
                  <c:v>15.7</c:v>
                </c:pt>
                <c:pt idx="121">
                  <c:v>15.7</c:v>
                </c:pt>
                <c:pt idx="122">
                  <c:v>14.3</c:v>
                </c:pt>
                <c:pt idx="123">
                  <c:v>10.5</c:v>
                </c:pt>
                <c:pt idx="124">
                  <c:v>10.7</c:v>
                </c:pt>
                <c:pt idx="125">
                  <c:v>8.80000000000000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1AC4-4C9D-98D0-AF7FF4CB0686}"/>
            </c:ext>
          </c:extLst>
        </c:ser>
        <c:marker val="1"/>
        <c:axId val="53635712"/>
        <c:axId val="53653888"/>
      </c:lineChart>
      <c:dateAx>
        <c:axId val="53635712"/>
        <c:scaling>
          <c:orientation val="minMax"/>
        </c:scaling>
        <c:axPos val="b"/>
        <c:numFmt formatCode="m/d/yyyy" sourceLinked="0"/>
        <c:tickLblPos val="nextTo"/>
        <c:spPr>
          <a:ln w="19050">
            <a:solidFill>
              <a:schemeClr val="tx1"/>
            </a:solidFill>
          </a:ln>
        </c:spPr>
        <c:crossAx val="53653888"/>
        <c:crosses val="autoZero"/>
        <c:auto val="1"/>
        <c:lblOffset val="100"/>
        <c:baseTimeUnit val="days"/>
      </c:dateAx>
      <c:valAx>
        <c:axId val="53653888"/>
        <c:scaling>
          <c:orientation val="minMax"/>
        </c:scaling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Temperature </a:t>
                </a:r>
                <a:r>
                  <a:rPr lang="ja-JP"/>
                  <a:t>（℃）</a:t>
                </a:r>
              </a:p>
            </c:rich>
          </c:tx>
          <c:layout/>
        </c:title>
        <c:numFmt formatCode="General" sourceLinked="1"/>
        <c:majorTickMark val="in"/>
        <c:tickLblPos val="nextTo"/>
        <c:spPr>
          <a:ln w="19050">
            <a:solidFill>
              <a:schemeClr val="tx1"/>
            </a:solidFill>
          </a:ln>
        </c:spPr>
        <c:crossAx val="53635712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</c:chart>
  <c:txPr>
    <a:bodyPr/>
    <a:lstStyle/>
    <a:p>
      <a:pPr>
        <a:defRPr b="0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/>
      <c:lineChart>
        <c:grouping val="standard"/>
        <c:ser>
          <c:idx val="2"/>
          <c:order val="0"/>
          <c:tx>
            <c:strRef>
              <c:f>'2016'!$E$1</c:f>
              <c:strCache>
                <c:ptCount val="1"/>
                <c:pt idx="0">
                  <c:v>最高気温</c:v>
                </c:pt>
              </c:strCache>
            </c:strRef>
          </c:tx>
          <c:spPr>
            <a:ln w="19050">
              <a:solidFill>
                <a:schemeClr val="tx1">
                  <a:lumMod val="95000"/>
                  <a:lumOff val="5000"/>
                </a:schemeClr>
              </a:solidFill>
            </a:ln>
          </c:spPr>
          <c:marker>
            <c:symbol val="none"/>
          </c:marker>
          <c:cat>
            <c:numRef>
              <c:f>'2016'!$B$25:$B$154</c:f>
              <c:numCache>
                <c:formatCode>mm"月"dd"日"</c:formatCode>
                <c:ptCount val="130"/>
                <c:pt idx="0">
                  <c:v>42514</c:v>
                </c:pt>
                <c:pt idx="1">
                  <c:v>42515</c:v>
                </c:pt>
                <c:pt idx="2">
                  <c:v>42516</c:v>
                </c:pt>
                <c:pt idx="3">
                  <c:v>42517</c:v>
                </c:pt>
                <c:pt idx="4">
                  <c:v>42518</c:v>
                </c:pt>
                <c:pt idx="5">
                  <c:v>42519</c:v>
                </c:pt>
                <c:pt idx="6">
                  <c:v>42520</c:v>
                </c:pt>
                <c:pt idx="7">
                  <c:v>42521</c:v>
                </c:pt>
                <c:pt idx="8">
                  <c:v>42522</c:v>
                </c:pt>
                <c:pt idx="9">
                  <c:v>42523</c:v>
                </c:pt>
                <c:pt idx="10">
                  <c:v>42524</c:v>
                </c:pt>
                <c:pt idx="11">
                  <c:v>42525</c:v>
                </c:pt>
                <c:pt idx="12">
                  <c:v>42526</c:v>
                </c:pt>
                <c:pt idx="13">
                  <c:v>42527</c:v>
                </c:pt>
                <c:pt idx="14">
                  <c:v>42528</c:v>
                </c:pt>
                <c:pt idx="15">
                  <c:v>42529</c:v>
                </c:pt>
                <c:pt idx="16">
                  <c:v>42530</c:v>
                </c:pt>
                <c:pt idx="17">
                  <c:v>42531</c:v>
                </c:pt>
                <c:pt idx="18">
                  <c:v>42532</c:v>
                </c:pt>
                <c:pt idx="19">
                  <c:v>42533</c:v>
                </c:pt>
                <c:pt idx="20">
                  <c:v>42534</c:v>
                </c:pt>
                <c:pt idx="21">
                  <c:v>42535</c:v>
                </c:pt>
                <c:pt idx="22">
                  <c:v>42536</c:v>
                </c:pt>
                <c:pt idx="23">
                  <c:v>42537</c:v>
                </c:pt>
                <c:pt idx="24">
                  <c:v>42538</c:v>
                </c:pt>
                <c:pt idx="25">
                  <c:v>42539</c:v>
                </c:pt>
                <c:pt idx="26">
                  <c:v>42540</c:v>
                </c:pt>
                <c:pt idx="27">
                  <c:v>42541</c:v>
                </c:pt>
                <c:pt idx="28">
                  <c:v>42542</c:v>
                </c:pt>
                <c:pt idx="29">
                  <c:v>42543</c:v>
                </c:pt>
                <c:pt idx="30">
                  <c:v>42544</c:v>
                </c:pt>
                <c:pt idx="31">
                  <c:v>42545</c:v>
                </c:pt>
                <c:pt idx="32">
                  <c:v>42546</c:v>
                </c:pt>
                <c:pt idx="33">
                  <c:v>42547</c:v>
                </c:pt>
                <c:pt idx="34">
                  <c:v>42548</c:v>
                </c:pt>
                <c:pt idx="35">
                  <c:v>42549</c:v>
                </c:pt>
                <c:pt idx="36">
                  <c:v>42550</c:v>
                </c:pt>
                <c:pt idx="37">
                  <c:v>42551</c:v>
                </c:pt>
                <c:pt idx="38">
                  <c:v>42552</c:v>
                </c:pt>
                <c:pt idx="39">
                  <c:v>42553</c:v>
                </c:pt>
                <c:pt idx="40">
                  <c:v>42554</c:v>
                </c:pt>
                <c:pt idx="41">
                  <c:v>42555</c:v>
                </c:pt>
                <c:pt idx="42">
                  <c:v>42556</c:v>
                </c:pt>
                <c:pt idx="43">
                  <c:v>42557</c:v>
                </c:pt>
                <c:pt idx="44">
                  <c:v>42558</c:v>
                </c:pt>
                <c:pt idx="45">
                  <c:v>42559</c:v>
                </c:pt>
                <c:pt idx="46">
                  <c:v>42560</c:v>
                </c:pt>
                <c:pt idx="47">
                  <c:v>42561</c:v>
                </c:pt>
                <c:pt idx="48">
                  <c:v>42562</c:v>
                </c:pt>
                <c:pt idx="49">
                  <c:v>42563</c:v>
                </c:pt>
                <c:pt idx="50">
                  <c:v>42564</c:v>
                </c:pt>
                <c:pt idx="51">
                  <c:v>42565</c:v>
                </c:pt>
                <c:pt idx="52">
                  <c:v>42566</c:v>
                </c:pt>
                <c:pt idx="53">
                  <c:v>42567</c:v>
                </c:pt>
                <c:pt idx="54">
                  <c:v>42568</c:v>
                </c:pt>
                <c:pt idx="55">
                  <c:v>42569</c:v>
                </c:pt>
                <c:pt idx="56">
                  <c:v>42570</c:v>
                </c:pt>
                <c:pt idx="57">
                  <c:v>42571</c:v>
                </c:pt>
                <c:pt idx="58">
                  <c:v>42572</c:v>
                </c:pt>
                <c:pt idx="59">
                  <c:v>42573</c:v>
                </c:pt>
                <c:pt idx="60">
                  <c:v>42574</c:v>
                </c:pt>
                <c:pt idx="61">
                  <c:v>42575</c:v>
                </c:pt>
                <c:pt idx="62">
                  <c:v>42576</c:v>
                </c:pt>
                <c:pt idx="63">
                  <c:v>42577</c:v>
                </c:pt>
                <c:pt idx="64">
                  <c:v>42578</c:v>
                </c:pt>
                <c:pt idx="65">
                  <c:v>42579</c:v>
                </c:pt>
                <c:pt idx="66">
                  <c:v>42580</c:v>
                </c:pt>
                <c:pt idx="67">
                  <c:v>42581</c:v>
                </c:pt>
                <c:pt idx="68">
                  <c:v>42582</c:v>
                </c:pt>
                <c:pt idx="69">
                  <c:v>42583</c:v>
                </c:pt>
                <c:pt idx="70">
                  <c:v>42584</c:v>
                </c:pt>
                <c:pt idx="71">
                  <c:v>42585</c:v>
                </c:pt>
                <c:pt idx="72">
                  <c:v>42586</c:v>
                </c:pt>
                <c:pt idx="73">
                  <c:v>42587</c:v>
                </c:pt>
                <c:pt idx="74">
                  <c:v>42588</c:v>
                </c:pt>
                <c:pt idx="75">
                  <c:v>42589</c:v>
                </c:pt>
                <c:pt idx="76">
                  <c:v>42590</c:v>
                </c:pt>
                <c:pt idx="77">
                  <c:v>42591</c:v>
                </c:pt>
                <c:pt idx="78">
                  <c:v>42592</c:v>
                </c:pt>
                <c:pt idx="79">
                  <c:v>42593</c:v>
                </c:pt>
                <c:pt idx="80">
                  <c:v>42594</c:v>
                </c:pt>
                <c:pt idx="81">
                  <c:v>42595</c:v>
                </c:pt>
                <c:pt idx="82">
                  <c:v>42596</c:v>
                </c:pt>
                <c:pt idx="83">
                  <c:v>42597</c:v>
                </c:pt>
                <c:pt idx="84">
                  <c:v>42598</c:v>
                </c:pt>
                <c:pt idx="85">
                  <c:v>42599</c:v>
                </c:pt>
                <c:pt idx="86">
                  <c:v>42600</c:v>
                </c:pt>
                <c:pt idx="87">
                  <c:v>42601</c:v>
                </c:pt>
                <c:pt idx="88">
                  <c:v>42602</c:v>
                </c:pt>
                <c:pt idx="89">
                  <c:v>42603</c:v>
                </c:pt>
                <c:pt idx="90">
                  <c:v>42604</c:v>
                </c:pt>
                <c:pt idx="91">
                  <c:v>42605</c:v>
                </c:pt>
                <c:pt idx="92">
                  <c:v>42606</c:v>
                </c:pt>
                <c:pt idx="93">
                  <c:v>42607</c:v>
                </c:pt>
                <c:pt idx="94">
                  <c:v>42608</c:v>
                </c:pt>
                <c:pt idx="95">
                  <c:v>42609</c:v>
                </c:pt>
                <c:pt idx="96">
                  <c:v>42610</c:v>
                </c:pt>
                <c:pt idx="97">
                  <c:v>42611</c:v>
                </c:pt>
                <c:pt idx="98">
                  <c:v>42612</c:v>
                </c:pt>
                <c:pt idx="99">
                  <c:v>42613</c:v>
                </c:pt>
                <c:pt idx="100">
                  <c:v>42614</c:v>
                </c:pt>
                <c:pt idx="101">
                  <c:v>42615</c:v>
                </c:pt>
                <c:pt idx="102">
                  <c:v>42616</c:v>
                </c:pt>
                <c:pt idx="103">
                  <c:v>42617</c:v>
                </c:pt>
                <c:pt idx="104">
                  <c:v>42618</c:v>
                </c:pt>
                <c:pt idx="105">
                  <c:v>42619</c:v>
                </c:pt>
                <c:pt idx="106">
                  <c:v>42620</c:v>
                </c:pt>
                <c:pt idx="107">
                  <c:v>42621</c:v>
                </c:pt>
                <c:pt idx="108">
                  <c:v>42622</c:v>
                </c:pt>
                <c:pt idx="109">
                  <c:v>42623</c:v>
                </c:pt>
                <c:pt idx="110">
                  <c:v>42624</c:v>
                </c:pt>
                <c:pt idx="111">
                  <c:v>42625</c:v>
                </c:pt>
                <c:pt idx="112">
                  <c:v>42626</c:v>
                </c:pt>
                <c:pt idx="113">
                  <c:v>42627</c:v>
                </c:pt>
                <c:pt idx="114">
                  <c:v>42628</c:v>
                </c:pt>
                <c:pt idx="115">
                  <c:v>42629</c:v>
                </c:pt>
                <c:pt idx="116">
                  <c:v>42630</c:v>
                </c:pt>
                <c:pt idx="117">
                  <c:v>42631</c:v>
                </c:pt>
                <c:pt idx="118">
                  <c:v>42632</c:v>
                </c:pt>
                <c:pt idx="119">
                  <c:v>42633</c:v>
                </c:pt>
                <c:pt idx="120">
                  <c:v>42634</c:v>
                </c:pt>
                <c:pt idx="121">
                  <c:v>42635</c:v>
                </c:pt>
                <c:pt idx="122">
                  <c:v>42636</c:v>
                </c:pt>
                <c:pt idx="123">
                  <c:v>42637</c:v>
                </c:pt>
                <c:pt idx="124">
                  <c:v>42638</c:v>
                </c:pt>
                <c:pt idx="125">
                  <c:v>42639</c:v>
                </c:pt>
                <c:pt idx="126">
                  <c:v>42640</c:v>
                </c:pt>
                <c:pt idx="127">
                  <c:v>42641</c:v>
                </c:pt>
                <c:pt idx="128">
                  <c:v>42642</c:v>
                </c:pt>
                <c:pt idx="129">
                  <c:v>42643</c:v>
                </c:pt>
              </c:numCache>
            </c:numRef>
          </c:cat>
          <c:val>
            <c:numRef>
              <c:f>'2016'!$E$25:$E$154</c:f>
              <c:numCache>
                <c:formatCode>General</c:formatCode>
                <c:ptCount val="130"/>
                <c:pt idx="0">
                  <c:v>25.1</c:v>
                </c:pt>
                <c:pt idx="1">
                  <c:v>22.1</c:v>
                </c:pt>
                <c:pt idx="2">
                  <c:v>24.5</c:v>
                </c:pt>
                <c:pt idx="3">
                  <c:v>23.5</c:v>
                </c:pt>
                <c:pt idx="4">
                  <c:v>23.6</c:v>
                </c:pt>
                <c:pt idx="5">
                  <c:v>22.8</c:v>
                </c:pt>
                <c:pt idx="6">
                  <c:v>23.9</c:v>
                </c:pt>
                <c:pt idx="7">
                  <c:v>22.2</c:v>
                </c:pt>
                <c:pt idx="8">
                  <c:v>20.5</c:v>
                </c:pt>
                <c:pt idx="9">
                  <c:v>18.8</c:v>
                </c:pt>
                <c:pt idx="10">
                  <c:v>21.8</c:v>
                </c:pt>
                <c:pt idx="11">
                  <c:v>24</c:v>
                </c:pt>
                <c:pt idx="12">
                  <c:v>25.6</c:v>
                </c:pt>
                <c:pt idx="13">
                  <c:v>21.1</c:v>
                </c:pt>
                <c:pt idx="14">
                  <c:v>20.7</c:v>
                </c:pt>
                <c:pt idx="15">
                  <c:v>22.5</c:v>
                </c:pt>
                <c:pt idx="16">
                  <c:v>21.7</c:v>
                </c:pt>
                <c:pt idx="17">
                  <c:v>29.1</c:v>
                </c:pt>
                <c:pt idx="18">
                  <c:v>27.8</c:v>
                </c:pt>
                <c:pt idx="19">
                  <c:v>24.1</c:v>
                </c:pt>
                <c:pt idx="20">
                  <c:v>20.399999999999999</c:v>
                </c:pt>
                <c:pt idx="21">
                  <c:v>20.9</c:v>
                </c:pt>
                <c:pt idx="22">
                  <c:v>19.5</c:v>
                </c:pt>
                <c:pt idx="23">
                  <c:v>20.6</c:v>
                </c:pt>
                <c:pt idx="24">
                  <c:v>26.5</c:v>
                </c:pt>
                <c:pt idx="25">
                  <c:v>27.1</c:v>
                </c:pt>
                <c:pt idx="26">
                  <c:v>23.4</c:v>
                </c:pt>
                <c:pt idx="27">
                  <c:v>23.3</c:v>
                </c:pt>
                <c:pt idx="28">
                  <c:v>25.2</c:v>
                </c:pt>
                <c:pt idx="29">
                  <c:v>23.9</c:v>
                </c:pt>
                <c:pt idx="30">
                  <c:v>18.2</c:v>
                </c:pt>
                <c:pt idx="31">
                  <c:v>22.1</c:v>
                </c:pt>
                <c:pt idx="32">
                  <c:v>25.8</c:v>
                </c:pt>
                <c:pt idx="33">
                  <c:v>23</c:v>
                </c:pt>
                <c:pt idx="34">
                  <c:v>26.3</c:v>
                </c:pt>
                <c:pt idx="35">
                  <c:v>20.5</c:v>
                </c:pt>
                <c:pt idx="36">
                  <c:v>24.9</c:v>
                </c:pt>
                <c:pt idx="37">
                  <c:v>20.9</c:v>
                </c:pt>
                <c:pt idx="38">
                  <c:v>28.5</c:v>
                </c:pt>
                <c:pt idx="39">
                  <c:v>23.4</c:v>
                </c:pt>
                <c:pt idx="40">
                  <c:v>27.8</c:v>
                </c:pt>
                <c:pt idx="41">
                  <c:v>28.5</c:v>
                </c:pt>
                <c:pt idx="42">
                  <c:v>20.100000000000001</c:v>
                </c:pt>
                <c:pt idx="43">
                  <c:v>20.9</c:v>
                </c:pt>
                <c:pt idx="44">
                  <c:v>23.6</c:v>
                </c:pt>
                <c:pt idx="45">
                  <c:v>25.1</c:v>
                </c:pt>
                <c:pt idx="46">
                  <c:v>24.7</c:v>
                </c:pt>
                <c:pt idx="47">
                  <c:v>28.7</c:v>
                </c:pt>
                <c:pt idx="48">
                  <c:v>29.2</c:v>
                </c:pt>
                <c:pt idx="49">
                  <c:v>26.3</c:v>
                </c:pt>
                <c:pt idx="50">
                  <c:v>25.9</c:v>
                </c:pt>
                <c:pt idx="51">
                  <c:v>26.3</c:v>
                </c:pt>
                <c:pt idx="52">
                  <c:v>25.6</c:v>
                </c:pt>
                <c:pt idx="53">
                  <c:v>24</c:v>
                </c:pt>
                <c:pt idx="54">
                  <c:v>24.7</c:v>
                </c:pt>
                <c:pt idx="55">
                  <c:v>29.8</c:v>
                </c:pt>
                <c:pt idx="56">
                  <c:v>29.4</c:v>
                </c:pt>
                <c:pt idx="57">
                  <c:v>25.9</c:v>
                </c:pt>
                <c:pt idx="58">
                  <c:v>23.6</c:v>
                </c:pt>
                <c:pt idx="59">
                  <c:v>24.6</c:v>
                </c:pt>
                <c:pt idx="60">
                  <c:v>24.3</c:v>
                </c:pt>
                <c:pt idx="61">
                  <c:v>25.4</c:v>
                </c:pt>
                <c:pt idx="62">
                  <c:v>26.8</c:v>
                </c:pt>
                <c:pt idx="63">
                  <c:v>25.9</c:v>
                </c:pt>
                <c:pt idx="64">
                  <c:v>26.5</c:v>
                </c:pt>
                <c:pt idx="65">
                  <c:v>27.8</c:v>
                </c:pt>
                <c:pt idx="66">
                  <c:v>29.4</c:v>
                </c:pt>
                <c:pt idx="67">
                  <c:v>29.4</c:v>
                </c:pt>
                <c:pt idx="68">
                  <c:v>29.8</c:v>
                </c:pt>
                <c:pt idx="69">
                  <c:v>30.7</c:v>
                </c:pt>
                <c:pt idx="70">
                  <c:v>29.7</c:v>
                </c:pt>
                <c:pt idx="71">
                  <c:v>29.2</c:v>
                </c:pt>
                <c:pt idx="72">
                  <c:v>32.6</c:v>
                </c:pt>
                <c:pt idx="73">
                  <c:v>33.4</c:v>
                </c:pt>
                <c:pt idx="74">
                  <c:v>31.9</c:v>
                </c:pt>
                <c:pt idx="75">
                  <c:v>30.4</c:v>
                </c:pt>
                <c:pt idx="76">
                  <c:v>31</c:v>
                </c:pt>
                <c:pt idx="77">
                  <c:v>32.1</c:v>
                </c:pt>
                <c:pt idx="78">
                  <c:v>29.1</c:v>
                </c:pt>
                <c:pt idx="79">
                  <c:v>28.3</c:v>
                </c:pt>
                <c:pt idx="80">
                  <c:v>28.1</c:v>
                </c:pt>
                <c:pt idx="81">
                  <c:v>26.9</c:v>
                </c:pt>
                <c:pt idx="82">
                  <c:v>27.4</c:v>
                </c:pt>
                <c:pt idx="83">
                  <c:v>27.5</c:v>
                </c:pt>
                <c:pt idx="84">
                  <c:v>29.8</c:v>
                </c:pt>
                <c:pt idx="85">
                  <c:v>30.3</c:v>
                </c:pt>
                <c:pt idx="86">
                  <c:v>26.7</c:v>
                </c:pt>
                <c:pt idx="87">
                  <c:v>29.3</c:v>
                </c:pt>
                <c:pt idx="88">
                  <c:v>29.1</c:v>
                </c:pt>
                <c:pt idx="89">
                  <c:v>31.9</c:v>
                </c:pt>
                <c:pt idx="90">
                  <c:v>29.1</c:v>
                </c:pt>
                <c:pt idx="91">
                  <c:v>30.9</c:v>
                </c:pt>
                <c:pt idx="92">
                  <c:v>28.2</c:v>
                </c:pt>
                <c:pt idx="93">
                  <c:v>28</c:v>
                </c:pt>
                <c:pt idx="94">
                  <c:v>29</c:v>
                </c:pt>
                <c:pt idx="95">
                  <c:v>22.1</c:v>
                </c:pt>
                <c:pt idx="96">
                  <c:v>24.5</c:v>
                </c:pt>
                <c:pt idx="97">
                  <c:v>27.4</c:v>
                </c:pt>
                <c:pt idx="98">
                  <c:v>27.3</c:v>
                </c:pt>
                <c:pt idx="99">
                  <c:v>27.5</c:v>
                </c:pt>
                <c:pt idx="100">
                  <c:v>29.1</c:v>
                </c:pt>
                <c:pt idx="101">
                  <c:v>27.9</c:v>
                </c:pt>
                <c:pt idx="102">
                  <c:v>27.7</c:v>
                </c:pt>
                <c:pt idx="103">
                  <c:v>28.7</c:v>
                </c:pt>
                <c:pt idx="104">
                  <c:v>29.8</c:v>
                </c:pt>
                <c:pt idx="105">
                  <c:v>30.3</c:v>
                </c:pt>
                <c:pt idx="106">
                  <c:v>28.4</c:v>
                </c:pt>
                <c:pt idx="107">
                  <c:v>24.9</c:v>
                </c:pt>
                <c:pt idx="108">
                  <c:v>29.1</c:v>
                </c:pt>
                <c:pt idx="109">
                  <c:v>28.9</c:v>
                </c:pt>
                <c:pt idx="110">
                  <c:v>22.2</c:v>
                </c:pt>
                <c:pt idx="111">
                  <c:v>22.5</c:v>
                </c:pt>
                <c:pt idx="112">
                  <c:v>20.3</c:v>
                </c:pt>
                <c:pt idx="113">
                  <c:v>25.6</c:v>
                </c:pt>
                <c:pt idx="114">
                  <c:v>27.8</c:v>
                </c:pt>
                <c:pt idx="115">
                  <c:v>24.8</c:v>
                </c:pt>
                <c:pt idx="116">
                  <c:v>24.6</c:v>
                </c:pt>
                <c:pt idx="117">
                  <c:v>19.600000000000001</c:v>
                </c:pt>
                <c:pt idx="118">
                  <c:v>19.8</c:v>
                </c:pt>
                <c:pt idx="119">
                  <c:v>18.5</c:v>
                </c:pt>
                <c:pt idx="120">
                  <c:v>22.7</c:v>
                </c:pt>
                <c:pt idx="121">
                  <c:v>22.3</c:v>
                </c:pt>
                <c:pt idx="122">
                  <c:v>24.2</c:v>
                </c:pt>
                <c:pt idx="123">
                  <c:v>25.3</c:v>
                </c:pt>
                <c:pt idx="124">
                  <c:v>25.3</c:v>
                </c:pt>
                <c:pt idx="125">
                  <c:v>24.8</c:v>
                </c:pt>
                <c:pt idx="126">
                  <c:v>24.9</c:v>
                </c:pt>
                <c:pt idx="127">
                  <c:v>24.5</c:v>
                </c:pt>
                <c:pt idx="128">
                  <c:v>21.9</c:v>
                </c:pt>
                <c:pt idx="129">
                  <c:v>21.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802-4DA9-8ECA-7D808C8E7E83}"/>
            </c:ext>
          </c:extLst>
        </c:ser>
        <c:ser>
          <c:idx val="0"/>
          <c:order val="1"/>
          <c:tx>
            <c:strRef>
              <c:f>'2016'!$D$1</c:f>
              <c:strCache>
                <c:ptCount val="1"/>
                <c:pt idx="0">
                  <c:v>平均気温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none"/>
          </c:marker>
          <c:cat>
            <c:numRef>
              <c:f>'2016'!$B$25:$B$154</c:f>
              <c:numCache>
                <c:formatCode>mm"月"dd"日"</c:formatCode>
                <c:ptCount val="130"/>
                <c:pt idx="0">
                  <c:v>42514</c:v>
                </c:pt>
                <c:pt idx="1">
                  <c:v>42515</c:v>
                </c:pt>
                <c:pt idx="2">
                  <c:v>42516</c:v>
                </c:pt>
                <c:pt idx="3">
                  <c:v>42517</c:v>
                </c:pt>
                <c:pt idx="4">
                  <c:v>42518</c:v>
                </c:pt>
                <c:pt idx="5">
                  <c:v>42519</c:v>
                </c:pt>
                <c:pt idx="6">
                  <c:v>42520</c:v>
                </c:pt>
                <c:pt idx="7">
                  <c:v>42521</c:v>
                </c:pt>
                <c:pt idx="8">
                  <c:v>42522</c:v>
                </c:pt>
                <c:pt idx="9">
                  <c:v>42523</c:v>
                </c:pt>
                <c:pt idx="10">
                  <c:v>42524</c:v>
                </c:pt>
                <c:pt idx="11">
                  <c:v>42525</c:v>
                </c:pt>
                <c:pt idx="12">
                  <c:v>42526</c:v>
                </c:pt>
                <c:pt idx="13">
                  <c:v>42527</c:v>
                </c:pt>
                <c:pt idx="14">
                  <c:v>42528</c:v>
                </c:pt>
                <c:pt idx="15">
                  <c:v>42529</c:v>
                </c:pt>
                <c:pt idx="16">
                  <c:v>42530</c:v>
                </c:pt>
                <c:pt idx="17">
                  <c:v>42531</c:v>
                </c:pt>
                <c:pt idx="18">
                  <c:v>42532</c:v>
                </c:pt>
                <c:pt idx="19">
                  <c:v>42533</c:v>
                </c:pt>
                <c:pt idx="20">
                  <c:v>42534</c:v>
                </c:pt>
                <c:pt idx="21">
                  <c:v>42535</c:v>
                </c:pt>
                <c:pt idx="22">
                  <c:v>42536</c:v>
                </c:pt>
                <c:pt idx="23">
                  <c:v>42537</c:v>
                </c:pt>
                <c:pt idx="24">
                  <c:v>42538</c:v>
                </c:pt>
                <c:pt idx="25">
                  <c:v>42539</c:v>
                </c:pt>
                <c:pt idx="26">
                  <c:v>42540</c:v>
                </c:pt>
                <c:pt idx="27">
                  <c:v>42541</c:v>
                </c:pt>
                <c:pt idx="28">
                  <c:v>42542</c:v>
                </c:pt>
                <c:pt idx="29">
                  <c:v>42543</c:v>
                </c:pt>
                <c:pt idx="30">
                  <c:v>42544</c:v>
                </c:pt>
                <c:pt idx="31">
                  <c:v>42545</c:v>
                </c:pt>
                <c:pt idx="32">
                  <c:v>42546</c:v>
                </c:pt>
                <c:pt idx="33">
                  <c:v>42547</c:v>
                </c:pt>
                <c:pt idx="34">
                  <c:v>42548</c:v>
                </c:pt>
                <c:pt idx="35">
                  <c:v>42549</c:v>
                </c:pt>
                <c:pt idx="36">
                  <c:v>42550</c:v>
                </c:pt>
                <c:pt idx="37">
                  <c:v>42551</c:v>
                </c:pt>
                <c:pt idx="38">
                  <c:v>42552</c:v>
                </c:pt>
                <c:pt idx="39">
                  <c:v>42553</c:v>
                </c:pt>
                <c:pt idx="40">
                  <c:v>42554</c:v>
                </c:pt>
                <c:pt idx="41">
                  <c:v>42555</c:v>
                </c:pt>
                <c:pt idx="42">
                  <c:v>42556</c:v>
                </c:pt>
                <c:pt idx="43">
                  <c:v>42557</c:v>
                </c:pt>
                <c:pt idx="44">
                  <c:v>42558</c:v>
                </c:pt>
                <c:pt idx="45">
                  <c:v>42559</c:v>
                </c:pt>
                <c:pt idx="46">
                  <c:v>42560</c:v>
                </c:pt>
                <c:pt idx="47">
                  <c:v>42561</c:v>
                </c:pt>
                <c:pt idx="48">
                  <c:v>42562</c:v>
                </c:pt>
                <c:pt idx="49">
                  <c:v>42563</c:v>
                </c:pt>
                <c:pt idx="50">
                  <c:v>42564</c:v>
                </c:pt>
                <c:pt idx="51">
                  <c:v>42565</c:v>
                </c:pt>
                <c:pt idx="52">
                  <c:v>42566</c:v>
                </c:pt>
                <c:pt idx="53">
                  <c:v>42567</c:v>
                </c:pt>
                <c:pt idx="54">
                  <c:v>42568</c:v>
                </c:pt>
                <c:pt idx="55">
                  <c:v>42569</c:v>
                </c:pt>
                <c:pt idx="56">
                  <c:v>42570</c:v>
                </c:pt>
                <c:pt idx="57">
                  <c:v>42571</c:v>
                </c:pt>
                <c:pt idx="58">
                  <c:v>42572</c:v>
                </c:pt>
                <c:pt idx="59">
                  <c:v>42573</c:v>
                </c:pt>
                <c:pt idx="60">
                  <c:v>42574</c:v>
                </c:pt>
                <c:pt idx="61">
                  <c:v>42575</c:v>
                </c:pt>
                <c:pt idx="62">
                  <c:v>42576</c:v>
                </c:pt>
                <c:pt idx="63">
                  <c:v>42577</c:v>
                </c:pt>
                <c:pt idx="64">
                  <c:v>42578</c:v>
                </c:pt>
                <c:pt idx="65">
                  <c:v>42579</c:v>
                </c:pt>
                <c:pt idx="66">
                  <c:v>42580</c:v>
                </c:pt>
                <c:pt idx="67">
                  <c:v>42581</c:v>
                </c:pt>
                <c:pt idx="68">
                  <c:v>42582</c:v>
                </c:pt>
                <c:pt idx="69">
                  <c:v>42583</c:v>
                </c:pt>
                <c:pt idx="70">
                  <c:v>42584</c:v>
                </c:pt>
                <c:pt idx="71">
                  <c:v>42585</c:v>
                </c:pt>
                <c:pt idx="72">
                  <c:v>42586</c:v>
                </c:pt>
                <c:pt idx="73">
                  <c:v>42587</c:v>
                </c:pt>
                <c:pt idx="74">
                  <c:v>42588</c:v>
                </c:pt>
                <c:pt idx="75">
                  <c:v>42589</c:v>
                </c:pt>
                <c:pt idx="76">
                  <c:v>42590</c:v>
                </c:pt>
                <c:pt idx="77">
                  <c:v>42591</c:v>
                </c:pt>
                <c:pt idx="78">
                  <c:v>42592</c:v>
                </c:pt>
                <c:pt idx="79">
                  <c:v>42593</c:v>
                </c:pt>
                <c:pt idx="80">
                  <c:v>42594</c:v>
                </c:pt>
                <c:pt idx="81">
                  <c:v>42595</c:v>
                </c:pt>
                <c:pt idx="82">
                  <c:v>42596</c:v>
                </c:pt>
                <c:pt idx="83">
                  <c:v>42597</c:v>
                </c:pt>
                <c:pt idx="84">
                  <c:v>42598</c:v>
                </c:pt>
                <c:pt idx="85">
                  <c:v>42599</c:v>
                </c:pt>
                <c:pt idx="86">
                  <c:v>42600</c:v>
                </c:pt>
                <c:pt idx="87">
                  <c:v>42601</c:v>
                </c:pt>
                <c:pt idx="88">
                  <c:v>42602</c:v>
                </c:pt>
                <c:pt idx="89">
                  <c:v>42603</c:v>
                </c:pt>
                <c:pt idx="90">
                  <c:v>42604</c:v>
                </c:pt>
                <c:pt idx="91">
                  <c:v>42605</c:v>
                </c:pt>
                <c:pt idx="92">
                  <c:v>42606</c:v>
                </c:pt>
                <c:pt idx="93">
                  <c:v>42607</c:v>
                </c:pt>
                <c:pt idx="94">
                  <c:v>42608</c:v>
                </c:pt>
                <c:pt idx="95">
                  <c:v>42609</c:v>
                </c:pt>
                <c:pt idx="96">
                  <c:v>42610</c:v>
                </c:pt>
                <c:pt idx="97">
                  <c:v>42611</c:v>
                </c:pt>
                <c:pt idx="98">
                  <c:v>42612</c:v>
                </c:pt>
                <c:pt idx="99">
                  <c:v>42613</c:v>
                </c:pt>
                <c:pt idx="100">
                  <c:v>42614</c:v>
                </c:pt>
                <c:pt idx="101">
                  <c:v>42615</c:v>
                </c:pt>
                <c:pt idx="102">
                  <c:v>42616</c:v>
                </c:pt>
                <c:pt idx="103">
                  <c:v>42617</c:v>
                </c:pt>
                <c:pt idx="104">
                  <c:v>42618</c:v>
                </c:pt>
                <c:pt idx="105">
                  <c:v>42619</c:v>
                </c:pt>
                <c:pt idx="106">
                  <c:v>42620</c:v>
                </c:pt>
                <c:pt idx="107">
                  <c:v>42621</c:v>
                </c:pt>
                <c:pt idx="108">
                  <c:v>42622</c:v>
                </c:pt>
                <c:pt idx="109">
                  <c:v>42623</c:v>
                </c:pt>
                <c:pt idx="110">
                  <c:v>42624</c:v>
                </c:pt>
                <c:pt idx="111">
                  <c:v>42625</c:v>
                </c:pt>
                <c:pt idx="112">
                  <c:v>42626</c:v>
                </c:pt>
                <c:pt idx="113">
                  <c:v>42627</c:v>
                </c:pt>
                <c:pt idx="114">
                  <c:v>42628</c:v>
                </c:pt>
                <c:pt idx="115">
                  <c:v>42629</c:v>
                </c:pt>
                <c:pt idx="116">
                  <c:v>42630</c:v>
                </c:pt>
                <c:pt idx="117">
                  <c:v>42631</c:v>
                </c:pt>
                <c:pt idx="118">
                  <c:v>42632</c:v>
                </c:pt>
                <c:pt idx="119">
                  <c:v>42633</c:v>
                </c:pt>
                <c:pt idx="120">
                  <c:v>42634</c:v>
                </c:pt>
                <c:pt idx="121">
                  <c:v>42635</c:v>
                </c:pt>
                <c:pt idx="122">
                  <c:v>42636</c:v>
                </c:pt>
                <c:pt idx="123">
                  <c:v>42637</c:v>
                </c:pt>
                <c:pt idx="124">
                  <c:v>42638</c:v>
                </c:pt>
                <c:pt idx="125">
                  <c:v>42639</c:v>
                </c:pt>
                <c:pt idx="126">
                  <c:v>42640</c:v>
                </c:pt>
                <c:pt idx="127">
                  <c:v>42641</c:v>
                </c:pt>
                <c:pt idx="128">
                  <c:v>42642</c:v>
                </c:pt>
                <c:pt idx="129">
                  <c:v>42643</c:v>
                </c:pt>
              </c:numCache>
            </c:numRef>
          </c:cat>
          <c:val>
            <c:numRef>
              <c:f>'2016'!$D$25:$D$154</c:f>
              <c:numCache>
                <c:formatCode>General</c:formatCode>
                <c:ptCount val="130"/>
                <c:pt idx="0">
                  <c:v>18.7</c:v>
                </c:pt>
                <c:pt idx="1">
                  <c:v>18.600000000000001</c:v>
                </c:pt>
                <c:pt idx="2">
                  <c:v>19.8</c:v>
                </c:pt>
                <c:pt idx="3">
                  <c:v>18.8</c:v>
                </c:pt>
                <c:pt idx="4">
                  <c:v>17.600000000000001</c:v>
                </c:pt>
                <c:pt idx="5">
                  <c:v>18.399999999999999</c:v>
                </c:pt>
                <c:pt idx="6">
                  <c:v>19.399999999999999</c:v>
                </c:pt>
                <c:pt idx="7">
                  <c:v>18.399999999999999</c:v>
                </c:pt>
                <c:pt idx="8">
                  <c:v>16.3</c:v>
                </c:pt>
                <c:pt idx="9">
                  <c:v>14.8</c:v>
                </c:pt>
                <c:pt idx="10">
                  <c:v>15.6</c:v>
                </c:pt>
                <c:pt idx="11">
                  <c:v>18.3</c:v>
                </c:pt>
                <c:pt idx="12">
                  <c:v>18.100000000000001</c:v>
                </c:pt>
                <c:pt idx="13">
                  <c:v>16.600000000000001</c:v>
                </c:pt>
                <c:pt idx="14">
                  <c:v>17.5</c:v>
                </c:pt>
                <c:pt idx="15">
                  <c:v>19.3</c:v>
                </c:pt>
                <c:pt idx="16">
                  <c:v>19.5</c:v>
                </c:pt>
                <c:pt idx="17">
                  <c:v>22.4</c:v>
                </c:pt>
                <c:pt idx="18">
                  <c:v>20.100000000000001</c:v>
                </c:pt>
                <c:pt idx="19">
                  <c:v>20.399999999999999</c:v>
                </c:pt>
                <c:pt idx="20">
                  <c:v>18</c:v>
                </c:pt>
                <c:pt idx="21">
                  <c:v>18.3</c:v>
                </c:pt>
                <c:pt idx="22">
                  <c:v>17.8</c:v>
                </c:pt>
                <c:pt idx="23">
                  <c:v>19</c:v>
                </c:pt>
                <c:pt idx="24">
                  <c:v>21.1</c:v>
                </c:pt>
                <c:pt idx="25">
                  <c:v>22.8</c:v>
                </c:pt>
                <c:pt idx="26">
                  <c:v>20.3</c:v>
                </c:pt>
                <c:pt idx="27">
                  <c:v>20.5</c:v>
                </c:pt>
                <c:pt idx="28">
                  <c:v>20.8</c:v>
                </c:pt>
                <c:pt idx="29">
                  <c:v>20</c:v>
                </c:pt>
                <c:pt idx="30">
                  <c:v>17.3</c:v>
                </c:pt>
                <c:pt idx="31">
                  <c:v>19.399999999999999</c:v>
                </c:pt>
                <c:pt idx="32">
                  <c:v>21.6</c:v>
                </c:pt>
                <c:pt idx="33">
                  <c:v>19.8</c:v>
                </c:pt>
                <c:pt idx="34">
                  <c:v>20.399999999999999</c:v>
                </c:pt>
                <c:pt idx="35">
                  <c:v>19.100000000000001</c:v>
                </c:pt>
                <c:pt idx="36">
                  <c:v>20.6</c:v>
                </c:pt>
                <c:pt idx="37">
                  <c:v>20.2</c:v>
                </c:pt>
                <c:pt idx="38">
                  <c:v>22.5</c:v>
                </c:pt>
                <c:pt idx="39">
                  <c:v>22</c:v>
                </c:pt>
                <c:pt idx="40">
                  <c:v>23.7</c:v>
                </c:pt>
                <c:pt idx="41">
                  <c:v>22.9</c:v>
                </c:pt>
                <c:pt idx="42">
                  <c:v>18.100000000000001</c:v>
                </c:pt>
                <c:pt idx="43">
                  <c:v>19.600000000000001</c:v>
                </c:pt>
                <c:pt idx="44">
                  <c:v>19.7</c:v>
                </c:pt>
                <c:pt idx="45">
                  <c:v>20.7</c:v>
                </c:pt>
                <c:pt idx="46">
                  <c:v>21.7</c:v>
                </c:pt>
                <c:pt idx="47">
                  <c:v>23.8</c:v>
                </c:pt>
                <c:pt idx="48">
                  <c:v>23.6</c:v>
                </c:pt>
                <c:pt idx="49">
                  <c:v>21.4</c:v>
                </c:pt>
                <c:pt idx="50">
                  <c:v>22.2</c:v>
                </c:pt>
                <c:pt idx="51">
                  <c:v>22.8</c:v>
                </c:pt>
                <c:pt idx="52">
                  <c:v>21.6</c:v>
                </c:pt>
                <c:pt idx="53">
                  <c:v>21.1</c:v>
                </c:pt>
                <c:pt idx="54">
                  <c:v>22.7</c:v>
                </c:pt>
                <c:pt idx="55">
                  <c:v>25.1</c:v>
                </c:pt>
                <c:pt idx="56">
                  <c:v>24.4</c:v>
                </c:pt>
                <c:pt idx="57">
                  <c:v>21.8</c:v>
                </c:pt>
                <c:pt idx="58">
                  <c:v>20.399999999999999</c:v>
                </c:pt>
                <c:pt idx="59">
                  <c:v>20.3</c:v>
                </c:pt>
                <c:pt idx="60">
                  <c:v>20</c:v>
                </c:pt>
                <c:pt idx="61">
                  <c:v>21</c:v>
                </c:pt>
                <c:pt idx="62">
                  <c:v>22.6</c:v>
                </c:pt>
                <c:pt idx="63">
                  <c:v>23.2</c:v>
                </c:pt>
                <c:pt idx="64">
                  <c:v>23.8</c:v>
                </c:pt>
                <c:pt idx="65">
                  <c:v>24.6</c:v>
                </c:pt>
                <c:pt idx="66">
                  <c:v>25.6</c:v>
                </c:pt>
                <c:pt idx="67">
                  <c:v>24.9</c:v>
                </c:pt>
                <c:pt idx="68">
                  <c:v>25.8</c:v>
                </c:pt>
                <c:pt idx="69">
                  <c:v>26</c:v>
                </c:pt>
                <c:pt idx="70">
                  <c:v>25</c:v>
                </c:pt>
                <c:pt idx="71">
                  <c:v>25.3</c:v>
                </c:pt>
                <c:pt idx="72">
                  <c:v>26.5</c:v>
                </c:pt>
                <c:pt idx="73">
                  <c:v>26.8</c:v>
                </c:pt>
                <c:pt idx="74">
                  <c:v>26.4</c:v>
                </c:pt>
                <c:pt idx="75">
                  <c:v>25.8</c:v>
                </c:pt>
                <c:pt idx="76">
                  <c:v>25.6</c:v>
                </c:pt>
                <c:pt idx="77">
                  <c:v>26.1</c:v>
                </c:pt>
                <c:pt idx="78">
                  <c:v>23.8</c:v>
                </c:pt>
                <c:pt idx="79">
                  <c:v>23.3</c:v>
                </c:pt>
                <c:pt idx="80">
                  <c:v>22.4</c:v>
                </c:pt>
                <c:pt idx="81">
                  <c:v>21.4</c:v>
                </c:pt>
                <c:pt idx="82">
                  <c:v>21.5</c:v>
                </c:pt>
                <c:pt idx="83">
                  <c:v>23.1</c:v>
                </c:pt>
                <c:pt idx="84">
                  <c:v>26.6</c:v>
                </c:pt>
                <c:pt idx="85">
                  <c:v>25.8</c:v>
                </c:pt>
                <c:pt idx="86">
                  <c:v>24.5</c:v>
                </c:pt>
                <c:pt idx="87">
                  <c:v>26.1</c:v>
                </c:pt>
                <c:pt idx="88">
                  <c:v>25.8</c:v>
                </c:pt>
                <c:pt idx="89">
                  <c:v>27</c:v>
                </c:pt>
                <c:pt idx="90">
                  <c:v>26.2</c:v>
                </c:pt>
                <c:pt idx="91">
                  <c:v>24.2</c:v>
                </c:pt>
                <c:pt idx="92">
                  <c:v>23.9</c:v>
                </c:pt>
                <c:pt idx="93">
                  <c:v>25.4</c:v>
                </c:pt>
                <c:pt idx="94">
                  <c:v>25.3</c:v>
                </c:pt>
                <c:pt idx="95">
                  <c:v>20.2</c:v>
                </c:pt>
                <c:pt idx="96">
                  <c:v>20.9</c:v>
                </c:pt>
                <c:pt idx="97">
                  <c:v>24.2</c:v>
                </c:pt>
                <c:pt idx="98">
                  <c:v>24</c:v>
                </c:pt>
                <c:pt idx="99">
                  <c:v>23.5</c:v>
                </c:pt>
                <c:pt idx="100">
                  <c:v>24.2</c:v>
                </c:pt>
                <c:pt idx="101">
                  <c:v>23.1</c:v>
                </c:pt>
                <c:pt idx="102">
                  <c:v>23.6</c:v>
                </c:pt>
                <c:pt idx="103">
                  <c:v>24.6</c:v>
                </c:pt>
                <c:pt idx="104">
                  <c:v>26</c:v>
                </c:pt>
                <c:pt idx="105">
                  <c:v>26.4</c:v>
                </c:pt>
                <c:pt idx="106">
                  <c:v>23.3</c:v>
                </c:pt>
                <c:pt idx="107">
                  <c:v>21.8</c:v>
                </c:pt>
                <c:pt idx="108">
                  <c:v>23.4</c:v>
                </c:pt>
                <c:pt idx="109">
                  <c:v>21.9</c:v>
                </c:pt>
                <c:pt idx="110">
                  <c:v>19.899999999999999</c:v>
                </c:pt>
                <c:pt idx="111">
                  <c:v>20.399999999999999</c:v>
                </c:pt>
                <c:pt idx="112">
                  <c:v>19.3</c:v>
                </c:pt>
                <c:pt idx="113">
                  <c:v>21.2</c:v>
                </c:pt>
                <c:pt idx="114">
                  <c:v>21.7</c:v>
                </c:pt>
                <c:pt idx="115">
                  <c:v>21.5</c:v>
                </c:pt>
                <c:pt idx="116">
                  <c:v>21</c:v>
                </c:pt>
                <c:pt idx="117">
                  <c:v>18.899999999999999</c:v>
                </c:pt>
                <c:pt idx="118">
                  <c:v>18.5</c:v>
                </c:pt>
                <c:pt idx="119">
                  <c:v>16.7</c:v>
                </c:pt>
                <c:pt idx="120">
                  <c:v>17.8</c:v>
                </c:pt>
                <c:pt idx="121">
                  <c:v>18.100000000000001</c:v>
                </c:pt>
                <c:pt idx="122">
                  <c:v>19.399999999999999</c:v>
                </c:pt>
                <c:pt idx="123">
                  <c:v>20.5</c:v>
                </c:pt>
                <c:pt idx="124">
                  <c:v>21.1</c:v>
                </c:pt>
                <c:pt idx="125">
                  <c:v>21.3</c:v>
                </c:pt>
                <c:pt idx="126">
                  <c:v>21.7</c:v>
                </c:pt>
                <c:pt idx="127">
                  <c:v>22.5</c:v>
                </c:pt>
                <c:pt idx="128">
                  <c:v>18.399999999999999</c:v>
                </c:pt>
                <c:pt idx="129">
                  <c:v>15.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802-4DA9-8ECA-7D808C8E7E83}"/>
            </c:ext>
          </c:extLst>
        </c:ser>
        <c:ser>
          <c:idx val="4"/>
          <c:order val="2"/>
          <c:spPr>
            <a:ln w="19050">
              <a:solidFill>
                <a:prstClr val="white">
                  <a:lumMod val="50000"/>
                </a:prstClr>
              </a:solidFill>
            </a:ln>
          </c:spPr>
          <c:marker>
            <c:symbol val="none"/>
          </c:marker>
          <c:cat>
            <c:numRef>
              <c:f>'2016'!$B$25:$B$154</c:f>
              <c:numCache>
                <c:formatCode>mm"月"dd"日"</c:formatCode>
                <c:ptCount val="130"/>
                <c:pt idx="0">
                  <c:v>42514</c:v>
                </c:pt>
                <c:pt idx="1">
                  <c:v>42515</c:v>
                </c:pt>
                <c:pt idx="2">
                  <c:v>42516</c:v>
                </c:pt>
                <c:pt idx="3">
                  <c:v>42517</c:v>
                </c:pt>
                <c:pt idx="4">
                  <c:v>42518</c:v>
                </c:pt>
                <c:pt idx="5">
                  <c:v>42519</c:v>
                </c:pt>
                <c:pt idx="6">
                  <c:v>42520</c:v>
                </c:pt>
                <c:pt idx="7">
                  <c:v>42521</c:v>
                </c:pt>
                <c:pt idx="8">
                  <c:v>42522</c:v>
                </c:pt>
                <c:pt idx="9">
                  <c:v>42523</c:v>
                </c:pt>
                <c:pt idx="10">
                  <c:v>42524</c:v>
                </c:pt>
                <c:pt idx="11">
                  <c:v>42525</c:v>
                </c:pt>
                <c:pt idx="12">
                  <c:v>42526</c:v>
                </c:pt>
                <c:pt idx="13">
                  <c:v>42527</c:v>
                </c:pt>
                <c:pt idx="14">
                  <c:v>42528</c:v>
                </c:pt>
                <c:pt idx="15">
                  <c:v>42529</c:v>
                </c:pt>
                <c:pt idx="16">
                  <c:v>42530</c:v>
                </c:pt>
                <c:pt idx="17">
                  <c:v>42531</c:v>
                </c:pt>
                <c:pt idx="18">
                  <c:v>42532</c:v>
                </c:pt>
                <c:pt idx="19">
                  <c:v>42533</c:v>
                </c:pt>
                <c:pt idx="20">
                  <c:v>42534</c:v>
                </c:pt>
                <c:pt idx="21">
                  <c:v>42535</c:v>
                </c:pt>
                <c:pt idx="22">
                  <c:v>42536</c:v>
                </c:pt>
                <c:pt idx="23">
                  <c:v>42537</c:v>
                </c:pt>
                <c:pt idx="24">
                  <c:v>42538</c:v>
                </c:pt>
                <c:pt idx="25">
                  <c:v>42539</c:v>
                </c:pt>
                <c:pt idx="26">
                  <c:v>42540</c:v>
                </c:pt>
                <c:pt idx="27">
                  <c:v>42541</c:v>
                </c:pt>
                <c:pt idx="28">
                  <c:v>42542</c:v>
                </c:pt>
                <c:pt idx="29">
                  <c:v>42543</c:v>
                </c:pt>
                <c:pt idx="30">
                  <c:v>42544</c:v>
                </c:pt>
                <c:pt idx="31">
                  <c:v>42545</c:v>
                </c:pt>
                <c:pt idx="32">
                  <c:v>42546</c:v>
                </c:pt>
                <c:pt idx="33">
                  <c:v>42547</c:v>
                </c:pt>
                <c:pt idx="34">
                  <c:v>42548</c:v>
                </c:pt>
                <c:pt idx="35">
                  <c:v>42549</c:v>
                </c:pt>
                <c:pt idx="36">
                  <c:v>42550</c:v>
                </c:pt>
                <c:pt idx="37">
                  <c:v>42551</c:v>
                </c:pt>
                <c:pt idx="38">
                  <c:v>42552</c:v>
                </c:pt>
                <c:pt idx="39">
                  <c:v>42553</c:v>
                </c:pt>
                <c:pt idx="40">
                  <c:v>42554</c:v>
                </c:pt>
                <c:pt idx="41">
                  <c:v>42555</c:v>
                </c:pt>
                <c:pt idx="42">
                  <c:v>42556</c:v>
                </c:pt>
                <c:pt idx="43">
                  <c:v>42557</c:v>
                </c:pt>
                <c:pt idx="44">
                  <c:v>42558</c:v>
                </c:pt>
                <c:pt idx="45">
                  <c:v>42559</c:v>
                </c:pt>
                <c:pt idx="46">
                  <c:v>42560</c:v>
                </c:pt>
                <c:pt idx="47">
                  <c:v>42561</c:v>
                </c:pt>
                <c:pt idx="48">
                  <c:v>42562</c:v>
                </c:pt>
                <c:pt idx="49">
                  <c:v>42563</c:v>
                </c:pt>
                <c:pt idx="50">
                  <c:v>42564</c:v>
                </c:pt>
                <c:pt idx="51">
                  <c:v>42565</c:v>
                </c:pt>
                <c:pt idx="52">
                  <c:v>42566</c:v>
                </c:pt>
                <c:pt idx="53">
                  <c:v>42567</c:v>
                </c:pt>
                <c:pt idx="54">
                  <c:v>42568</c:v>
                </c:pt>
                <c:pt idx="55">
                  <c:v>42569</c:v>
                </c:pt>
                <c:pt idx="56">
                  <c:v>42570</c:v>
                </c:pt>
                <c:pt idx="57">
                  <c:v>42571</c:v>
                </c:pt>
                <c:pt idx="58">
                  <c:v>42572</c:v>
                </c:pt>
                <c:pt idx="59">
                  <c:v>42573</c:v>
                </c:pt>
                <c:pt idx="60">
                  <c:v>42574</c:v>
                </c:pt>
                <c:pt idx="61">
                  <c:v>42575</c:v>
                </c:pt>
                <c:pt idx="62">
                  <c:v>42576</c:v>
                </c:pt>
                <c:pt idx="63">
                  <c:v>42577</c:v>
                </c:pt>
                <c:pt idx="64">
                  <c:v>42578</c:v>
                </c:pt>
                <c:pt idx="65">
                  <c:v>42579</c:v>
                </c:pt>
                <c:pt idx="66">
                  <c:v>42580</c:v>
                </c:pt>
                <c:pt idx="67">
                  <c:v>42581</c:v>
                </c:pt>
                <c:pt idx="68">
                  <c:v>42582</c:v>
                </c:pt>
                <c:pt idx="69">
                  <c:v>42583</c:v>
                </c:pt>
                <c:pt idx="70">
                  <c:v>42584</c:v>
                </c:pt>
                <c:pt idx="71">
                  <c:v>42585</c:v>
                </c:pt>
                <c:pt idx="72">
                  <c:v>42586</c:v>
                </c:pt>
                <c:pt idx="73">
                  <c:v>42587</c:v>
                </c:pt>
                <c:pt idx="74">
                  <c:v>42588</c:v>
                </c:pt>
                <c:pt idx="75">
                  <c:v>42589</c:v>
                </c:pt>
                <c:pt idx="76">
                  <c:v>42590</c:v>
                </c:pt>
                <c:pt idx="77">
                  <c:v>42591</c:v>
                </c:pt>
                <c:pt idx="78">
                  <c:v>42592</c:v>
                </c:pt>
                <c:pt idx="79">
                  <c:v>42593</c:v>
                </c:pt>
                <c:pt idx="80">
                  <c:v>42594</c:v>
                </c:pt>
                <c:pt idx="81">
                  <c:v>42595</c:v>
                </c:pt>
                <c:pt idx="82">
                  <c:v>42596</c:v>
                </c:pt>
                <c:pt idx="83">
                  <c:v>42597</c:v>
                </c:pt>
                <c:pt idx="84">
                  <c:v>42598</c:v>
                </c:pt>
                <c:pt idx="85">
                  <c:v>42599</c:v>
                </c:pt>
                <c:pt idx="86">
                  <c:v>42600</c:v>
                </c:pt>
                <c:pt idx="87">
                  <c:v>42601</c:v>
                </c:pt>
                <c:pt idx="88">
                  <c:v>42602</c:v>
                </c:pt>
                <c:pt idx="89">
                  <c:v>42603</c:v>
                </c:pt>
                <c:pt idx="90">
                  <c:v>42604</c:v>
                </c:pt>
                <c:pt idx="91">
                  <c:v>42605</c:v>
                </c:pt>
                <c:pt idx="92">
                  <c:v>42606</c:v>
                </c:pt>
                <c:pt idx="93">
                  <c:v>42607</c:v>
                </c:pt>
                <c:pt idx="94">
                  <c:v>42608</c:v>
                </c:pt>
                <c:pt idx="95">
                  <c:v>42609</c:v>
                </c:pt>
                <c:pt idx="96">
                  <c:v>42610</c:v>
                </c:pt>
                <c:pt idx="97">
                  <c:v>42611</c:v>
                </c:pt>
                <c:pt idx="98">
                  <c:v>42612</c:v>
                </c:pt>
                <c:pt idx="99">
                  <c:v>42613</c:v>
                </c:pt>
                <c:pt idx="100">
                  <c:v>42614</c:v>
                </c:pt>
                <c:pt idx="101">
                  <c:v>42615</c:v>
                </c:pt>
                <c:pt idx="102">
                  <c:v>42616</c:v>
                </c:pt>
                <c:pt idx="103">
                  <c:v>42617</c:v>
                </c:pt>
                <c:pt idx="104">
                  <c:v>42618</c:v>
                </c:pt>
                <c:pt idx="105">
                  <c:v>42619</c:v>
                </c:pt>
                <c:pt idx="106">
                  <c:v>42620</c:v>
                </c:pt>
                <c:pt idx="107">
                  <c:v>42621</c:v>
                </c:pt>
                <c:pt idx="108">
                  <c:v>42622</c:v>
                </c:pt>
                <c:pt idx="109">
                  <c:v>42623</c:v>
                </c:pt>
                <c:pt idx="110">
                  <c:v>42624</c:v>
                </c:pt>
                <c:pt idx="111">
                  <c:v>42625</c:v>
                </c:pt>
                <c:pt idx="112">
                  <c:v>42626</c:v>
                </c:pt>
                <c:pt idx="113">
                  <c:v>42627</c:v>
                </c:pt>
                <c:pt idx="114">
                  <c:v>42628</c:v>
                </c:pt>
                <c:pt idx="115">
                  <c:v>42629</c:v>
                </c:pt>
                <c:pt idx="116">
                  <c:v>42630</c:v>
                </c:pt>
                <c:pt idx="117">
                  <c:v>42631</c:v>
                </c:pt>
                <c:pt idx="118">
                  <c:v>42632</c:v>
                </c:pt>
                <c:pt idx="119">
                  <c:v>42633</c:v>
                </c:pt>
                <c:pt idx="120">
                  <c:v>42634</c:v>
                </c:pt>
                <c:pt idx="121">
                  <c:v>42635</c:v>
                </c:pt>
                <c:pt idx="122">
                  <c:v>42636</c:v>
                </c:pt>
                <c:pt idx="123">
                  <c:v>42637</c:v>
                </c:pt>
                <c:pt idx="124">
                  <c:v>42638</c:v>
                </c:pt>
                <c:pt idx="125">
                  <c:v>42639</c:v>
                </c:pt>
                <c:pt idx="126">
                  <c:v>42640</c:v>
                </c:pt>
                <c:pt idx="127">
                  <c:v>42641</c:v>
                </c:pt>
                <c:pt idx="128">
                  <c:v>42642</c:v>
                </c:pt>
                <c:pt idx="129">
                  <c:v>42643</c:v>
                </c:pt>
              </c:numCache>
            </c:numRef>
          </c:cat>
          <c:val>
            <c:numRef>
              <c:f>'2016'!$H$25:$H$154</c:f>
              <c:numCache>
                <c:formatCode>General</c:formatCode>
                <c:ptCount val="130"/>
                <c:pt idx="0">
                  <c:v>12.6</c:v>
                </c:pt>
                <c:pt idx="1">
                  <c:v>16.399999999999999</c:v>
                </c:pt>
                <c:pt idx="2">
                  <c:v>16.899999999999999</c:v>
                </c:pt>
                <c:pt idx="3">
                  <c:v>14.4</c:v>
                </c:pt>
                <c:pt idx="4">
                  <c:v>12.7</c:v>
                </c:pt>
                <c:pt idx="5">
                  <c:v>12.9</c:v>
                </c:pt>
                <c:pt idx="6">
                  <c:v>16.2</c:v>
                </c:pt>
                <c:pt idx="7">
                  <c:v>15.2</c:v>
                </c:pt>
                <c:pt idx="8">
                  <c:v>12.7</c:v>
                </c:pt>
                <c:pt idx="9">
                  <c:v>11.2</c:v>
                </c:pt>
                <c:pt idx="10">
                  <c:v>9.9</c:v>
                </c:pt>
                <c:pt idx="11">
                  <c:v>10.1</c:v>
                </c:pt>
                <c:pt idx="12">
                  <c:v>13.6</c:v>
                </c:pt>
                <c:pt idx="13">
                  <c:v>13.3</c:v>
                </c:pt>
                <c:pt idx="14">
                  <c:v>13.2</c:v>
                </c:pt>
                <c:pt idx="15">
                  <c:v>16.899999999999999</c:v>
                </c:pt>
                <c:pt idx="16">
                  <c:v>17.100000000000001</c:v>
                </c:pt>
                <c:pt idx="17">
                  <c:v>16.3</c:v>
                </c:pt>
                <c:pt idx="18">
                  <c:v>12.9</c:v>
                </c:pt>
                <c:pt idx="19">
                  <c:v>18.3</c:v>
                </c:pt>
                <c:pt idx="20">
                  <c:v>16.8</c:v>
                </c:pt>
                <c:pt idx="21">
                  <c:v>16.899999999999999</c:v>
                </c:pt>
                <c:pt idx="22">
                  <c:v>16.7</c:v>
                </c:pt>
                <c:pt idx="23">
                  <c:v>16.600000000000001</c:v>
                </c:pt>
                <c:pt idx="24">
                  <c:v>18.100000000000001</c:v>
                </c:pt>
                <c:pt idx="25">
                  <c:v>18</c:v>
                </c:pt>
                <c:pt idx="26">
                  <c:v>16.399999999999999</c:v>
                </c:pt>
                <c:pt idx="27">
                  <c:v>18.5</c:v>
                </c:pt>
                <c:pt idx="28">
                  <c:v>16.899999999999999</c:v>
                </c:pt>
                <c:pt idx="29">
                  <c:v>17</c:v>
                </c:pt>
                <c:pt idx="30">
                  <c:v>16.7</c:v>
                </c:pt>
                <c:pt idx="31">
                  <c:v>17</c:v>
                </c:pt>
                <c:pt idx="32">
                  <c:v>19.399999999999999</c:v>
                </c:pt>
                <c:pt idx="33">
                  <c:v>16.7</c:v>
                </c:pt>
                <c:pt idx="34">
                  <c:v>15.9</c:v>
                </c:pt>
                <c:pt idx="35">
                  <c:v>17.8</c:v>
                </c:pt>
                <c:pt idx="36">
                  <c:v>16.600000000000001</c:v>
                </c:pt>
                <c:pt idx="37">
                  <c:v>19.600000000000001</c:v>
                </c:pt>
                <c:pt idx="38">
                  <c:v>18.2</c:v>
                </c:pt>
                <c:pt idx="39">
                  <c:v>20.5</c:v>
                </c:pt>
                <c:pt idx="40">
                  <c:v>20.6</c:v>
                </c:pt>
                <c:pt idx="41">
                  <c:v>17.2</c:v>
                </c:pt>
                <c:pt idx="42">
                  <c:v>16.899999999999999</c:v>
                </c:pt>
                <c:pt idx="43">
                  <c:v>17</c:v>
                </c:pt>
                <c:pt idx="44">
                  <c:v>17.3</c:v>
                </c:pt>
                <c:pt idx="45">
                  <c:v>17.2</c:v>
                </c:pt>
                <c:pt idx="46">
                  <c:v>20.100000000000001</c:v>
                </c:pt>
                <c:pt idx="47">
                  <c:v>18.3</c:v>
                </c:pt>
                <c:pt idx="48">
                  <c:v>18.100000000000001</c:v>
                </c:pt>
                <c:pt idx="49">
                  <c:v>16.8</c:v>
                </c:pt>
                <c:pt idx="50">
                  <c:v>20</c:v>
                </c:pt>
                <c:pt idx="51">
                  <c:v>21.2</c:v>
                </c:pt>
                <c:pt idx="52">
                  <c:v>18.899999999999999</c:v>
                </c:pt>
                <c:pt idx="53">
                  <c:v>18.2</c:v>
                </c:pt>
                <c:pt idx="54">
                  <c:v>21.2</c:v>
                </c:pt>
                <c:pt idx="55">
                  <c:v>20.6</c:v>
                </c:pt>
                <c:pt idx="56">
                  <c:v>18.7</c:v>
                </c:pt>
                <c:pt idx="57">
                  <c:v>18.3</c:v>
                </c:pt>
                <c:pt idx="58">
                  <c:v>18.7</c:v>
                </c:pt>
                <c:pt idx="59">
                  <c:v>16.399999999999999</c:v>
                </c:pt>
                <c:pt idx="60">
                  <c:v>17.3</c:v>
                </c:pt>
                <c:pt idx="61">
                  <c:v>18.2</c:v>
                </c:pt>
                <c:pt idx="62">
                  <c:v>19.600000000000001</c:v>
                </c:pt>
                <c:pt idx="63">
                  <c:v>21.1</c:v>
                </c:pt>
                <c:pt idx="64">
                  <c:v>22.3</c:v>
                </c:pt>
                <c:pt idx="65">
                  <c:v>22.6</c:v>
                </c:pt>
                <c:pt idx="66">
                  <c:v>22.8</c:v>
                </c:pt>
                <c:pt idx="67">
                  <c:v>20.7</c:v>
                </c:pt>
                <c:pt idx="68">
                  <c:v>22.2</c:v>
                </c:pt>
                <c:pt idx="69">
                  <c:v>23.4</c:v>
                </c:pt>
                <c:pt idx="70">
                  <c:v>23</c:v>
                </c:pt>
                <c:pt idx="71">
                  <c:v>22.9</c:v>
                </c:pt>
                <c:pt idx="72">
                  <c:v>21.9</c:v>
                </c:pt>
                <c:pt idx="73">
                  <c:v>21.6</c:v>
                </c:pt>
                <c:pt idx="74">
                  <c:v>21.7</c:v>
                </c:pt>
                <c:pt idx="75">
                  <c:v>21</c:v>
                </c:pt>
                <c:pt idx="76">
                  <c:v>21.3</c:v>
                </c:pt>
                <c:pt idx="77">
                  <c:v>20.6</c:v>
                </c:pt>
                <c:pt idx="78">
                  <c:v>18.600000000000001</c:v>
                </c:pt>
                <c:pt idx="79">
                  <c:v>19.600000000000001</c:v>
                </c:pt>
                <c:pt idx="80">
                  <c:v>18.399999999999999</c:v>
                </c:pt>
                <c:pt idx="81">
                  <c:v>16.5</c:v>
                </c:pt>
                <c:pt idx="82">
                  <c:v>16.3</c:v>
                </c:pt>
                <c:pt idx="83">
                  <c:v>18</c:v>
                </c:pt>
                <c:pt idx="84">
                  <c:v>24</c:v>
                </c:pt>
                <c:pt idx="85">
                  <c:v>24.1</c:v>
                </c:pt>
                <c:pt idx="86">
                  <c:v>23.1</c:v>
                </c:pt>
                <c:pt idx="87">
                  <c:v>23.8</c:v>
                </c:pt>
                <c:pt idx="88">
                  <c:v>23.5</c:v>
                </c:pt>
                <c:pt idx="89">
                  <c:v>23</c:v>
                </c:pt>
                <c:pt idx="90">
                  <c:v>23.4</c:v>
                </c:pt>
                <c:pt idx="91">
                  <c:v>21</c:v>
                </c:pt>
                <c:pt idx="92">
                  <c:v>20.5</c:v>
                </c:pt>
                <c:pt idx="93">
                  <c:v>23.2</c:v>
                </c:pt>
                <c:pt idx="94">
                  <c:v>22</c:v>
                </c:pt>
                <c:pt idx="95">
                  <c:v>18.399999999999999</c:v>
                </c:pt>
                <c:pt idx="96">
                  <c:v>18.100000000000001</c:v>
                </c:pt>
                <c:pt idx="97">
                  <c:v>20.7</c:v>
                </c:pt>
                <c:pt idx="98">
                  <c:v>21.1</c:v>
                </c:pt>
                <c:pt idx="99">
                  <c:v>19.7</c:v>
                </c:pt>
                <c:pt idx="100">
                  <c:v>20.399999999999999</c:v>
                </c:pt>
                <c:pt idx="101">
                  <c:v>18.8</c:v>
                </c:pt>
                <c:pt idx="102">
                  <c:v>20.2</c:v>
                </c:pt>
                <c:pt idx="103">
                  <c:v>21.9</c:v>
                </c:pt>
                <c:pt idx="104">
                  <c:v>23.7</c:v>
                </c:pt>
                <c:pt idx="105">
                  <c:v>22.6</c:v>
                </c:pt>
                <c:pt idx="106">
                  <c:v>18.7</c:v>
                </c:pt>
                <c:pt idx="107">
                  <c:v>18.8</c:v>
                </c:pt>
                <c:pt idx="108">
                  <c:v>17.100000000000001</c:v>
                </c:pt>
                <c:pt idx="109">
                  <c:v>15.2</c:v>
                </c:pt>
                <c:pt idx="110">
                  <c:v>17.2</c:v>
                </c:pt>
                <c:pt idx="111">
                  <c:v>18.8</c:v>
                </c:pt>
                <c:pt idx="112">
                  <c:v>18.3</c:v>
                </c:pt>
                <c:pt idx="113">
                  <c:v>18.100000000000001</c:v>
                </c:pt>
                <c:pt idx="114">
                  <c:v>18</c:v>
                </c:pt>
                <c:pt idx="115">
                  <c:v>19.3</c:v>
                </c:pt>
                <c:pt idx="116">
                  <c:v>17.899999999999999</c:v>
                </c:pt>
                <c:pt idx="117">
                  <c:v>18.5</c:v>
                </c:pt>
                <c:pt idx="118">
                  <c:v>17.7</c:v>
                </c:pt>
                <c:pt idx="119">
                  <c:v>14.7</c:v>
                </c:pt>
                <c:pt idx="120">
                  <c:v>14.3</c:v>
                </c:pt>
                <c:pt idx="121">
                  <c:v>16.3</c:v>
                </c:pt>
                <c:pt idx="122">
                  <c:v>16.5</c:v>
                </c:pt>
                <c:pt idx="123">
                  <c:v>16.8</c:v>
                </c:pt>
                <c:pt idx="124">
                  <c:v>18.899999999999999</c:v>
                </c:pt>
                <c:pt idx="125">
                  <c:v>19.2</c:v>
                </c:pt>
                <c:pt idx="126">
                  <c:v>19.2</c:v>
                </c:pt>
                <c:pt idx="127">
                  <c:v>20.7</c:v>
                </c:pt>
                <c:pt idx="128">
                  <c:v>12.5</c:v>
                </c:pt>
                <c:pt idx="129">
                  <c:v>9.80000000000000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5802-4DA9-8ECA-7D808C8E7E83}"/>
            </c:ext>
          </c:extLst>
        </c:ser>
        <c:marker val="1"/>
        <c:axId val="55523584"/>
        <c:axId val="55529472"/>
      </c:lineChart>
      <c:dateAx>
        <c:axId val="55523584"/>
        <c:scaling>
          <c:orientation val="minMax"/>
        </c:scaling>
        <c:axPos val="b"/>
        <c:numFmt formatCode="m/d/yyyy" sourceLinked="0"/>
        <c:majorTickMark val="cross"/>
        <c:tickLblPos val="nextTo"/>
        <c:spPr>
          <a:ln w="19050">
            <a:solidFill>
              <a:schemeClr val="tx1"/>
            </a:solidFill>
          </a:ln>
        </c:spPr>
        <c:crossAx val="55529472"/>
        <c:crosses val="autoZero"/>
        <c:auto val="1"/>
        <c:lblOffset val="100"/>
        <c:baseTimeUnit val="days"/>
      </c:dateAx>
      <c:valAx>
        <c:axId val="55529472"/>
        <c:scaling>
          <c:orientation val="minMax"/>
        </c:scaling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Temperature </a:t>
                </a:r>
                <a:r>
                  <a:rPr lang="ja-JP"/>
                  <a:t>（℃）</a:t>
                </a:r>
              </a:p>
            </c:rich>
          </c:tx>
          <c:layout/>
        </c:title>
        <c:numFmt formatCode="General" sourceLinked="1"/>
        <c:majorTickMark val="in"/>
        <c:tickLblPos val="nextTo"/>
        <c:spPr>
          <a:ln w="19050">
            <a:solidFill>
              <a:schemeClr val="tx1"/>
            </a:solidFill>
          </a:ln>
        </c:spPr>
        <c:crossAx val="55523584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</c:chart>
  <c:txPr>
    <a:bodyPr/>
    <a:lstStyle/>
    <a:p>
      <a:pPr>
        <a:defRPr b="0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188" cy="501730"/>
          </a:xfrm>
          <a:prstGeom prst="rect">
            <a:avLst/>
          </a:prstGeom>
        </p:spPr>
        <p:txBody>
          <a:bodyPr vert="horz" lIns="91449" tIns="45725" rIns="91449" bIns="4572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902974" y="0"/>
            <a:ext cx="2985188" cy="501730"/>
          </a:xfrm>
          <a:prstGeom prst="rect">
            <a:avLst/>
          </a:prstGeom>
        </p:spPr>
        <p:txBody>
          <a:bodyPr vert="horz" lIns="91449" tIns="45725" rIns="91449" bIns="45725" rtlCol="0"/>
          <a:lstStyle>
            <a:lvl1pPr algn="r">
              <a:defRPr sz="1200"/>
            </a:lvl1pPr>
          </a:lstStyle>
          <a:p>
            <a:fld id="{F581287D-F438-4639-9446-93BE5642AE6B}" type="datetimeFigureOut">
              <a:rPr kumimoji="1" lang="ja-JP" altLang="en-US" smtClean="0"/>
              <a:pPr/>
              <a:t>2019/6/2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0" y="9518571"/>
            <a:ext cx="2985188" cy="501730"/>
          </a:xfrm>
          <a:prstGeom prst="rect">
            <a:avLst/>
          </a:prstGeom>
        </p:spPr>
        <p:txBody>
          <a:bodyPr vert="horz" lIns="91449" tIns="45725" rIns="91449" bIns="4572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902974" y="9518571"/>
            <a:ext cx="2985188" cy="501730"/>
          </a:xfrm>
          <a:prstGeom prst="rect">
            <a:avLst/>
          </a:prstGeom>
        </p:spPr>
        <p:txBody>
          <a:bodyPr vert="horz" lIns="91449" tIns="45725" rIns="91449" bIns="45725" rtlCol="0" anchor="b"/>
          <a:lstStyle>
            <a:lvl1pPr algn="r">
              <a:defRPr sz="1200"/>
            </a:lvl1pPr>
          </a:lstStyle>
          <a:p>
            <a:fld id="{F002D2FE-DDAD-443C-9C05-C0698CC18F2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0252-BB14-4532-A16D-DBF9F7678F8E}" type="datetimeFigureOut">
              <a:rPr kumimoji="1" lang="ja-JP" altLang="en-US" smtClean="0"/>
              <a:pPr/>
              <a:t>2019/6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273-0A63-4B35-AAC3-32DA2015D04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0252-BB14-4532-A16D-DBF9F7678F8E}" type="datetimeFigureOut">
              <a:rPr kumimoji="1" lang="ja-JP" altLang="en-US" smtClean="0"/>
              <a:pPr/>
              <a:t>2019/6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273-0A63-4B35-AAC3-32DA2015D04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0252-BB14-4532-A16D-DBF9F7678F8E}" type="datetimeFigureOut">
              <a:rPr kumimoji="1" lang="ja-JP" altLang="en-US" smtClean="0"/>
              <a:pPr/>
              <a:t>2019/6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273-0A63-4B35-AAC3-32DA2015D04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0252-BB14-4532-A16D-DBF9F7678F8E}" type="datetimeFigureOut">
              <a:rPr kumimoji="1" lang="ja-JP" altLang="en-US" smtClean="0"/>
              <a:pPr/>
              <a:t>2019/6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273-0A63-4B35-AAC3-32DA2015D04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0252-BB14-4532-A16D-DBF9F7678F8E}" type="datetimeFigureOut">
              <a:rPr kumimoji="1" lang="ja-JP" altLang="en-US" smtClean="0"/>
              <a:pPr/>
              <a:t>2019/6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273-0A63-4B35-AAC3-32DA2015D04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0252-BB14-4532-A16D-DBF9F7678F8E}" type="datetimeFigureOut">
              <a:rPr kumimoji="1" lang="ja-JP" altLang="en-US" smtClean="0"/>
              <a:pPr/>
              <a:t>2019/6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273-0A63-4B35-AAC3-32DA2015D04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0252-BB14-4532-A16D-DBF9F7678F8E}" type="datetimeFigureOut">
              <a:rPr kumimoji="1" lang="ja-JP" altLang="en-US" smtClean="0"/>
              <a:pPr/>
              <a:t>2019/6/2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273-0A63-4B35-AAC3-32DA2015D04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0252-BB14-4532-A16D-DBF9F7678F8E}" type="datetimeFigureOut">
              <a:rPr kumimoji="1" lang="ja-JP" altLang="en-US" smtClean="0"/>
              <a:pPr/>
              <a:t>2019/6/2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273-0A63-4B35-AAC3-32DA2015D04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0252-BB14-4532-A16D-DBF9F7678F8E}" type="datetimeFigureOut">
              <a:rPr kumimoji="1" lang="ja-JP" altLang="en-US" smtClean="0"/>
              <a:pPr/>
              <a:t>2019/6/2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273-0A63-4B35-AAC3-32DA2015D04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0252-BB14-4532-A16D-DBF9F7678F8E}" type="datetimeFigureOut">
              <a:rPr kumimoji="1" lang="ja-JP" altLang="en-US" smtClean="0"/>
              <a:pPr/>
              <a:t>2019/6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273-0A63-4B35-AAC3-32DA2015D04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0252-BB14-4532-A16D-DBF9F7678F8E}" type="datetimeFigureOut">
              <a:rPr kumimoji="1" lang="ja-JP" altLang="en-US" smtClean="0"/>
              <a:pPr/>
              <a:t>2019/6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273-0A63-4B35-AAC3-32DA2015D04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FC0252-BB14-4532-A16D-DBF9F7678F8E}" type="datetimeFigureOut">
              <a:rPr kumimoji="1" lang="ja-JP" altLang="en-US" smtClean="0"/>
              <a:pPr/>
              <a:t>2019/6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9C273-0A63-4B35-AAC3-32DA2015D04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/>
          <p:nvPr/>
        </p:nvGraphicFramePr>
        <p:xfrm>
          <a:off x="1052736" y="827584"/>
          <a:ext cx="5445224" cy="30962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/>
          <p:cNvGraphicFramePr>
            <a:graphicFrameLocks/>
          </p:cNvGraphicFramePr>
          <p:nvPr/>
        </p:nvGraphicFramePr>
        <p:xfrm>
          <a:off x="1053996" y="4139952"/>
          <a:ext cx="5455816" cy="32190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4" cstate="print"/>
          <a:srcRect l="48686" t="2610" r="43951" b="92738"/>
          <a:stretch>
            <a:fillRect/>
          </a:stretch>
        </p:blipFill>
        <p:spPr bwMode="auto">
          <a:xfrm>
            <a:off x="3811750" y="708462"/>
            <a:ext cx="398944" cy="1283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/>
          <a:srcRect l="34066" t="1517" r="58797" b="91265"/>
          <a:stretch>
            <a:fillRect/>
          </a:stretch>
        </p:blipFill>
        <p:spPr bwMode="auto">
          <a:xfrm>
            <a:off x="1922990" y="673063"/>
            <a:ext cx="386700" cy="1991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4" cstate="print"/>
          <a:srcRect l="62799" t="2898" r="29747" b="92395"/>
          <a:stretch>
            <a:fillRect/>
          </a:stretch>
        </p:blipFill>
        <p:spPr bwMode="auto">
          <a:xfrm>
            <a:off x="3809292" y="529566"/>
            <a:ext cx="403860" cy="1298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テキスト ボックス 8"/>
          <p:cNvSpPr txBox="1"/>
          <p:nvPr/>
        </p:nvSpPr>
        <p:spPr>
          <a:xfrm>
            <a:off x="4227246" y="467544"/>
            <a:ext cx="135806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Average temperature</a:t>
            </a:r>
            <a:endParaRPr kumimoji="1" lang="ja-JP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355038" y="645676"/>
            <a:ext cx="13949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Minimum temperature</a:t>
            </a:r>
            <a:endParaRPr kumimoji="1" lang="ja-JP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210210" y="645676"/>
            <a:ext cx="145103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Maximum temperature</a:t>
            </a:r>
            <a:endParaRPr kumimoji="1" lang="ja-JP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738070" y="899592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itchFamily="18" charset="0"/>
                <a:cs typeface="Times New Roman" pitchFamily="18" charset="0"/>
              </a:rPr>
              <a:t>2015</a:t>
            </a:r>
            <a:endParaRPr kumimoji="1" lang="ja-JP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738070" y="4238382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itchFamily="18" charset="0"/>
                <a:cs typeface="Times New Roman" pitchFamily="18" charset="0"/>
              </a:rPr>
              <a:t>2016</a:t>
            </a:r>
            <a:endParaRPr kumimoji="1" lang="ja-JP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="" xmlns:a16="http://schemas.microsoft.com/office/drawing/2014/main" id="{D75331CB-3308-4AEC-86E3-AC1A55F3D005}"/>
              </a:ext>
            </a:extLst>
          </p:cNvPr>
          <p:cNvSpPr txBox="1"/>
          <p:nvPr/>
        </p:nvSpPr>
        <p:spPr>
          <a:xfrm>
            <a:off x="1196752" y="7740352"/>
            <a:ext cx="513634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ily maximum, minimum and average air 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 during the experiments.</a:t>
            </a:r>
            <a:endParaRPr kumimoji="1" lang="en-US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41585838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/>
        </p:nvGraphicFramePr>
        <p:xfrm>
          <a:off x="1556792" y="179512"/>
          <a:ext cx="4392488" cy="7846571"/>
        </p:xfrm>
        <a:graphic>
          <a:graphicData uri="http://schemas.openxmlformats.org/drawingml/2006/table">
            <a:tbl>
              <a:tblPr/>
              <a:tblGrid>
                <a:gridCol w="469459"/>
                <a:gridCol w="217342"/>
                <a:gridCol w="469459"/>
                <a:gridCol w="228210"/>
                <a:gridCol w="228210"/>
                <a:gridCol w="469459"/>
                <a:gridCol w="469459"/>
                <a:gridCol w="469459"/>
                <a:gridCol w="217342"/>
                <a:gridCol w="469459"/>
                <a:gridCol w="228210"/>
                <a:gridCol w="228210"/>
                <a:gridCol w="228210"/>
              </a:tblGrid>
              <a:tr h="44036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marker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chr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latin typeface="Times New Roman"/>
                        </a:rPr>
                        <a:t>Position</a:t>
                      </a:r>
                      <a:r>
                        <a:rPr lang="en-US" sz="900" b="0" i="0" u="none" strike="noStrike">
                          <a:latin typeface="Osaka"/>
                        </a:rPr>
                        <a:t>（</a:t>
                      </a:r>
                      <a:r>
                        <a:rPr lang="en-US" sz="900" b="0" i="0" u="none" strike="noStrike">
                          <a:latin typeface="Times New Roman"/>
                        </a:rPr>
                        <a:t>Mb</a:t>
                      </a:r>
                      <a:r>
                        <a:rPr lang="en-US" sz="900" b="0" i="0" u="none" strike="noStrike">
                          <a:latin typeface="Osaka"/>
                        </a:rPr>
                        <a:t>）</a:t>
                      </a:r>
                      <a:br>
                        <a:rPr lang="en-US" sz="900" b="0" i="0" u="none" strike="noStrike">
                          <a:latin typeface="Osaka"/>
                        </a:rPr>
                      </a:br>
                      <a:r>
                        <a:rPr lang="en-US" sz="900" b="0" i="0" u="none" strike="noStrike">
                          <a:latin typeface="Times New Roman"/>
                        </a:rPr>
                        <a:t>build 4</a:t>
                      </a:r>
                    </a:p>
                  </a:txBody>
                  <a:tcPr marL="6536" marR="6536" marT="65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SL538</a:t>
                      </a:r>
                    </a:p>
                  </a:txBody>
                  <a:tcPr marL="6536" marR="6536" marT="6536" marB="0" vert="vert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SL541</a:t>
                      </a:r>
                    </a:p>
                  </a:txBody>
                  <a:tcPr marL="6536" marR="6536" marT="6536" marB="0" vert="vert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marker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chr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latin typeface="Times New Roman"/>
                        </a:rPr>
                        <a:t>Position</a:t>
                      </a:r>
                      <a:r>
                        <a:rPr lang="en-US" sz="900" b="0" i="0" u="none" strike="noStrike">
                          <a:latin typeface="Osaka"/>
                        </a:rPr>
                        <a:t>（</a:t>
                      </a:r>
                      <a:r>
                        <a:rPr lang="en-US" sz="900" b="0" i="0" u="none" strike="noStrike">
                          <a:latin typeface="Times New Roman"/>
                        </a:rPr>
                        <a:t>Mb</a:t>
                      </a:r>
                      <a:r>
                        <a:rPr lang="en-US" sz="900" b="0" i="0" u="none" strike="noStrike">
                          <a:latin typeface="Osaka"/>
                        </a:rPr>
                        <a:t>）</a:t>
                      </a:r>
                      <a:br>
                        <a:rPr lang="en-US" sz="900" b="0" i="0" u="none" strike="noStrike">
                          <a:latin typeface="Osaka"/>
                        </a:rPr>
                      </a:br>
                      <a:r>
                        <a:rPr lang="en-US" sz="900" b="0" i="0" u="none" strike="noStrike">
                          <a:latin typeface="Times New Roman"/>
                        </a:rPr>
                        <a:t>build 4</a:t>
                      </a:r>
                    </a:p>
                  </a:txBody>
                  <a:tcPr marL="6536" marR="6536" marT="65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SL501</a:t>
                      </a:r>
                    </a:p>
                  </a:txBody>
                  <a:tcPr marL="6536" marR="6536" marT="6536" marB="0" vert="vert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SL502</a:t>
                      </a:r>
                    </a:p>
                  </a:txBody>
                  <a:tcPr marL="6536" marR="6536" marT="6536" marB="0" vert="vert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SL503</a:t>
                      </a:r>
                    </a:p>
                  </a:txBody>
                  <a:tcPr marL="6536" marR="6536" marT="6536" marB="0" vert="vert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6887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0.2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6887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0.2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25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0.3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25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0.3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740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.8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740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.8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425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5.1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425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5.1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03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9.3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03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9.3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627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0.4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627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0.4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7075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5.4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7075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5.4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19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3.6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19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3.6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726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6.1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726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6.1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297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30.4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297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30.4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70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33.7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70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33.7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33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0.0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33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0.0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48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1.5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48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1.5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5310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3.0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5310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3.0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067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4.7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067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4.7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286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0.4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7158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0.2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7203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.1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2353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.1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33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.1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4608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.3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133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6.2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4128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6.6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7283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9.2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5963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8.8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573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0.0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187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1.8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7463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0.2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498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1.9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6680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0.9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5957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5.4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596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1.8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764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8.1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649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5.9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343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30.5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6623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7.0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50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31.8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233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8.8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6094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30.7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821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.5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592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30.8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E1828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8.5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328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9.8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latin typeface="Times New Roman"/>
                        </a:rPr>
                        <a:t>RM1880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0.7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9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1.4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latin typeface="Times New Roman"/>
                        </a:rPr>
                        <a:t>RM1208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.1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5657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5.0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66FF"/>
                    </a:solidFill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latin typeface="Times New Roman"/>
                        </a:rPr>
                        <a:t>RM3747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.3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E6155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8.3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latin typeface="Times New Roman"/>
                        </a:rPr>
                        <a:t>RM6998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.7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578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0.4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latin typeface="Times New Roman"/>
                        </a:rPr>
                        <a:t>RM761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.8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2144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3.0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latin typeface="Times New Roman"/>
                        </a:rPr>
                        <a:t>RM2935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7.4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6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205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3.6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latin typeface="Times New Roman"/>
                        </a:rPr>
                        <a:t>RM124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9.3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latin typeface="Times New Roman"/>
                        </a:rPr>
                        <a:t>RM686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2.5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880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0.7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latin typeface="Times New Roman"/>
                        </a:rPr>
                        <a:t>RM737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3.7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208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.1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B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latin typeface="Times New Roman"/>
                        </a:rPr>
                        <a:t>RM1300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6.2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3747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.3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latin typeface="Times New Roman"/>
                        </a:rPr>
                        <a:t>RM122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7.6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6998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.7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761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4.8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2935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7.4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24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9.3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6869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2.5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737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3.7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300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6.2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147"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latin typeface="Times New Roman"/>
                      </a:endParaRPr>
                    </a:p>
                  </a:txBody>
                  <a:tcPr marL="6536" marR="6536" marT="65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RM1226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12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latin typeface="Times New Roman"/>
                        </a:rPr>
                        <a:t>27.6 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latin typeface="Times New Roman"/>
                        </a:rPr>
                        <a:t>A</a:t>
                      </a:r>
                    </a:p>
                  </a:txBody>
                  <a:tcPr marL="6536" marR="6536" marT="65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="" xmlns:a16="http://schemas.microsoft.com/office/drawing/2014/main" id="{D75331CB-3308-4AEC-86E3-AC1A55F3D005}"/>
              </a:ext>
            </a:extLst>
          </p:cNvPr>
          <p:cNvSpPr txBox="1"/>
          <p:nvPr/>
        </p:nvSpPr>
        <p:spPr>
          <a:xfrm>
            <a:off x="404664" y="8100392"/>
            <a:ext cx="5688632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kumimoji="1"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stitution positions with Nona </a:t>
            </a:r>
            <a:r>
              <a:rPr lang="en-US" altLang="ja-JP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kra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hromosomes in SL501, 502, 503, 538 and 541.</a:t>
            </a:r>
          </a:p>
          <a:p>
            <a:r>
              <a:rPr lang="en-US" altLang="ja-JP" sz="105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ly chromosomes that have substitutions and chromosome 1 are shown.</a:t>
            </a:r>
            <a:r>
              <a:rPr kumimoji="1"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, homozygous for </a:t>
            </a:r>
            <a:r>
              <a:rPr kumimoji="1" lang="en-US" altLang="ja-JP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shihikari</a:t>
            </a:r>
            <a:r>
              <a:rPr kumimoji="1"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lleles. B, homozygous for Nona </a:t>
            </a:r>
            <a:r>
              <a:rPr kumimoji="1" lang="en-US" altLang="ja-JP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kra</a:t>
            </a:r>
            <a:r>
              <a:rPr kumimoji="1"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lleles. H, heterozygous. </a:t>
            </a:r>
            <a:r>
              <a:rPr kumimoji="1" lang="en-US" altLang="ja-JP" sz="105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romosome 1 </a:t>
            </a:r>
            <a:r>
              <a:rPr lang="en-US" altLang="ja-JP" sz="105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ains SKC1 (B allele from Nona </a:t>
            </a:r>
            <a:r>
              <a:rPr lang="en-US" altLang="ja-JP" sz="1050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okra</a:t>
            </a:r>
            <a:r>
              <a:rPr lang="en-US" altLang="ja-JP" sz="105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nd SL501, 502, 503 but not SL538 and 541 have the substitution in the chromosome. </a:t>
            </a:r>
            <a:r>
              <a:rPr kumimoji="1"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type data was obtained from the website of Rice Genome Resource Center (2007). </a:t>
            </a:r>
            <a:endParaRPr kumimoji="1" lang="en-US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/>
        </p:nvGraphicFramePr>
        <p:xfrm>
          <a:off x="1268760" y="2339752"/>
          <a:ext cx="3744595" cy="2541905"/>
        </p:xfrm>
        <a:graphic>
          <a:graphicData uri="http://schemas.openxmlformats.org/drawingml/2006/table">
            <a:tbl>
              <a:tblPr/>
              <a:tblGrid>
                <a:gridCol w="102997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235710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478915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17018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ja-JP" sz="1050" kern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　</a:t>
                      </a:r>
                      <a:r>
                        <a:rPr lang="en-US" altLang="ja-JP" sz="1050" kern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Ion species</a:t>
                      </a:r>
                      <a:endParaRPr lang="ja-JP" sz="1050" kern="100" dirty="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050" kern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Irrigation</a:t>
                      </a:r>
                      <a:r>
                        <a:rPr lang="en-US" altLang="ja-JP" sz="1050" kern="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 water</a:t>
                      </a:r>
                      <a:endParaRPr lang="ja-JP" sz="1050" kern="100" dirty="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ja-JP" sz="1050" kern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（</a:t>
                      </a:r>
                      <a:r>
                        <a:rPr lang="en-US" sz="1050" kern="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ppm</a:t>
                      </a:r>
                      <a:r>
                        <a:rPr lang="ja-JP" sz="1050" kern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）</a:t>
                      </a:r>
                      <a:endParaRPr lang="ja-JP" sz="1050" kern="100" dirty="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050" kern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Saline</a:t>
                      </a:r>
                      <a:r>
                        <a:rPr lang="en-US" altLang="ja-JP" sz="1050" kern="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 well water</a:t>
                      </a:r>
                      <a:endParaRPr lang="ja-JP" sz="1050" kern="100" dirty="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ja-JP" sz="1050" kern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（</a:t>
                      </a:r>
                      <a:r>
                        <a:rPr lang="en-US" sz="1050" kern="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ppm</a:t>
                      </a:r>
                      <a:r>
                        <a:rPr lang="ja-JP" sz="1050" kern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）</a:t>
                      </a:r>
                      <a:endParaRPr lang="ja-JP" sz="1050" kern="100" dirty="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Al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135890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0.08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250825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0.04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B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135890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0.02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250825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0.49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Ca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10.66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257810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670.57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Cl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14.76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8211.47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Fe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135890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0.03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250825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1.76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K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135890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2.37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257810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109.27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Mg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135890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3.42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257810" algn="dec"/>
                        </a:tabLs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299.67</a:t>
                      </a:r>
                      <a:endParaRPr lang="ja-JP" sz="1050" kern="100" dirty="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Mn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135890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0.00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250825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2.69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Na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135890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12.78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2344.26</a:t>
                      </a:r>
                      <a:endParaRPr lang="ja-JP" sz="1050" kern="100" dirty="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P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135890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0.13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250825" algn="dec"/>
                        </a:tabLs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0.25</a:t>
                      </a:r>
                      <a:endParaRPr lang="ja-JP" sz="1050" kern="100" dirty="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S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135890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6.84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250825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5.75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Si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11.86</a:t>
                      </a:r>
                      <a:endParaRPr lang="ja-JP" sz="1050" kern="100" dirty="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271780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13.63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Zn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135890" algn="dec"/>
                        </a:tabLs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0.00</a:t>
                      </a:r>
                      <a:endParaRPr lang="ja-JP" sz="1050" kern="10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250825" algn="dec"/>
                        </a:tabLs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ＭＳ 明朝"/>
                          <a:cs typeface="Times New Roman" pitchFamily="18" charset="0"/>
                        </a:rPr>
                        <a:t>0.00</a:t>
                      </a:r>
                      <a:endParaRPr lang="ja-JP" sz="1050" kern="100" dirty="0">
                        <a:latin typeface="Times New Roman" pitchFamily="18" charset="0"/>
                        <a:ea typeface="ＭＳ 明朝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1196752" y="1835696"/>
            <a:ext cx="45352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kumimoji="1" lang="en-US" altLang="ja-JP" sz="1050" b="1" dirty="0" smtClean="0">
                <a:latin typeface="Times New Roman" pitchFamily="18" charset="0"/>
                <a:cs typeface="Times New Roman" pitchFamily="18" charset="0"/>
              </a:rPr>
              <a:t>S1. </a:t>
            </a:r>
            <a:r>
              <a:rPr lang="en-US" altLang="ja-JP" sz="105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ja-JP" sz="1050" dirty="0">
                <a:latin typeface="Times New Roman" pitchFamily="18" charset="0"/>
                <a:cs typeface="Times New Roman" pitchFamily="18" charset="0"/>
              </a:rPr>
              <a:t>concentration of ions in the irrigation water and saline well water. </a:t>
            </a:r>
            <a:endParaRPr kumimoji="1" lang="ja-JP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620688" y="5076056"/>
            <a:ext cx="52565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itchFamily="18" charset="0"/>
                <a:cs typeface="Times New Roman" pitchFamily="18" charset="0"/>
              </a:rPr>
              <a:t>Water was sampled on September </a:t>
            </a:r>
            <a:r>
              <a:rPr lang="en-US" altLang="ja-JP" sz="1050" dirty="0" smtClean="0">
                <a:latin typeface="Times New Roman" pitchFamily="18" charset="0"/>
                <a:cs typeface="Times New Roman" pitchFamily="18" charset="0"/>
              </a:rPr>
              <a:t>23rd, </a:t>
            </a:r>
            <a:r>
              <a:rPr lang="en-US" altLang="ja-JP" sz="1050" dirty="0">
                <a:latin typeface="Times New Roman" pitchFamily="18" charset="0"/>
                <a:cs typeface="Times New Roman" pitchFamily="18" charset="0"/>
              </a:rPr>
              <a:t>2017, and the element concentration was measured using ion chromatography (for Cl</a:t>
            </a:r>
            <a:r>
              <a:rPr lang="en-US" altLang="ja-JP" sz="1050" baseline="30000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ja-JP" sz="1050" dirty="0">
                <a:latin typeface="Times New Roman" pitchFamily="18" charset="0"/>
                <a:cs typeface="Times New Roman" pitchFamily="18" charset="0"/>
              </a:rPr>
              <a:t>) and ICP-AES (for others). </a:t>
            </a:r>
            <a:endParaRPr kumimoji="1" lang="ja-JP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表 8"/>
          <p:cNvGraphicFramePr>
            <a:graphicFrameLocks noGrp="1"/>
          </p:cNvGraphicFramePr>
          <p:nvPr/>
        </p:nvGraphicFramePr>
        <p:xfrm>
          <a:off x="260648" y="2051720"/>
          <a:ext cx="6546282" cy="1252147"/>
        </p:xfrm>
        <a:graphic>
          <a:graphicData uri="http://schemas.openxmlformats.org/drawingml/2006/table">
            <a:tbl>
              <a:tblPr/>
              <a:tblGrid>
                <a:gridCol w="595368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636712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636712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636712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10253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636712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636712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636712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  <a:gridCol w="110253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  <a:gridCol w="636712">
                  <a:extLst>
                    <a:ext uri="{9D8B030D-6E8A-4147-A177-3AD203B41FA5}">
                      <a16:colId xmlns="" xmlns:a16="http://schemas.microsoft.com/office/drawing/2014/main" val="20009"/>
                    </a:ext>
                  </a:extLst>
                </a:gridCol>
                <a:gridCol w="636712">
                  <a:extLst>
                    <a:ext uri="{9D8B030D-6E8A-4147-A177-3AD203B41FA5}">
                      <a16:colId xmlns="" xmlns:a16="http://schemas.microsoft.com/office/drawing/2014/main" val="20010"/>
                    </a:ext>
                  </a:extLst>
                </a:gridCol>
                <a:gridCol w="636712">
                  <a:extLst>
                    <a:ext uri="{9D8B030D-6E8A-4147-A177-3AD203B41FA5}">
                      <a16:colId xmlns="" xmlns:a16="http://schemas.microsoft.com/office/drawing/2014/main" val="20011"/>
                    </a:ext>
                  </a:extLst>
                </a:gridCol>
              </a:tblGrid>
              <a:tr h="18782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emperature (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℃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)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ainfall (mm)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uration of sunshine (h)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85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onth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5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6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rmal value</a:t>
                      </a:r>
                      <a:r>
                        <a:rPr lang="en-US" sz="1000" b="0" i="0" u="none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5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6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rmal value</a:t>
                      </a:r>
                      <a:r>
                        <a:rPr lang="en-US" sz="1000" b="0" i="0" u="none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5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6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rmal value</a:t>
                      </a:r>
                      <a:r>
                        <a:rPr lang="en-US" sz="1000" b="0" i="0" u="none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878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June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9.1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.2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.4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9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5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2.2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8.1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6.4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0.5 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878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July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.7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.4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.8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8.5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.5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0.9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6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7.7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6.7 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878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ugust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.3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6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.5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7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2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9.1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3.8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4.1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8.3 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878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ptember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.4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1.1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.8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8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9.5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1.8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7.2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1.8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23.8 </a:t>
                      </a:r>
                    </a:p>
                  </a:txBody>
                  <a:tcPr marL="8237" marR="8237" marT="8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1" y="3347864"/>
            <a:ext cx="6858000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Note: Climatic data obtained from Automated Meteorological Data Acquisition system (</a:t>
            </a:r>
            <a:r>
              <a:rPr kumimoji="1" lang="en-US" altLang="ja-JP" sz="1050" dirty="0" err="1">
                <a:latin typeface="Times New Roman" pitchFamily="18" charset="0"/>
                <a:cs typeface="Times New Roman" pitchFamily="18" charset="0"/>
              </a:rPr>
              <a:t>AMeDAS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) in </a:t>
            </a:r>
            <a:r>
              <a:rPr kumimoji="1" lang="en-US" altLang="ja-JP" sz="1050" dirty="0" err="1">
                <a:latin typeface="Times New Roman" pitchFamily="18" charset="0"/>
                <a:cs typeface="Times New Roman" pitchFamily="18" charset="0"/>
              </a:rPr>
              <a:t>Kashimadai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 station (Osaki City, Miyagi, Japan; 38</a:t>
            </a:r>
            <a:r>
              <a:rPr lang="en-US" altLang="ja-JP" sz="1050" dirty="0">
                <a:latin typeface="Times New Roman" pitchFamily="18" charset="0"/>
                <a:cs typeface="Times New Roman" pitchFamily="18" charset="0"/>
              </a:rPr>
              <a:t>º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27´N, 141</a:t>
            </a:r>
            <a:r>
              <a:rPr lang="en-US" altLang="ja-JP" sz="1050" dirty="0">
                <a:latin typeface="Times New Roman" pitchFamily="18" charset="0"/>
                <a:cs typeface="Times New Roman" pitchFamily="18" charset="0"/>
              </a:rPr>
              <a:t>º05´E). </a:t>
            </a:r>
          </a:p>
          <a:p>
            <a:r>
              <a:rPr kumimoji="1" lang="en-US" altLang="ja-JP" sz="1050" baseline="30000" dirty="0" err="1">
                <a:latin typeface="Times New Roman" pitchFamily="18" charset="0"/>
                <a:cs typeface="Times New Roman" pitchFamily="18" charset="0"/>
              </a:rPr>
              <a:t>a</a:t>
            </a:r>
            <a:r>
              <a:rPr kumimoji="1" lang="en-US" altLang="ja-JP" sz="105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 values indicate averages of monthly temperatures, rainfall and duration of sunshine from 1985 to 2014. 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60648" y="1259632"/>
            <a:ext cx="659735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kumimoji="1" lang="en-US" altLang="ja-JP" sz="1050" b="1" dirty="0" smtClean="0">
                <a:latin typeface="Times New Roman" pitchFamily="18" charset="0"/>
                <a:cs typeface="Times New Roman" pitchFamily="18" charset="0"/>
              </a:rPr>
              <a:t>S2. </a:t>
            </a:r>
            <a:r>
              <a:rPr kumimoji="1" lang="en-US" altLang="ja-JP" sz="1050" dirty="0" smtClean="0">
                <a:latin typeface="Times New Roman" pitchFamily="18" charset="0"/>
                <a:cs typeface="Times New Roman" pitchFamily="18" charset="0"/>
              </a:rPr>
              <a:t>Average 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monthly temperature (</a:t>
            </a:r>
            <a:r>
              <a:rPr kumimoji="1" lang="ja-JP" altLang="en-US" sz="1050" dirty="0">
                <a:latin typeface="Times New Roman" pitchFamily="18" charset="0"/>
                <a:cs typeface="Times New Roman" pitchFamily="18" charset="0"/>
              </a:rPr>
              <a:t>℃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), rainfall (mm) and duration of sunshine (d) during the growth</a:t>
            </a:r>
            <a:r>
              <a:rPr lang="en-US" altLang="ja-JP" sz="1050" dirty="0">
                <a:latin typeface="Times New Roman" pitchFamily="18" charset="0"/>
                <a:cs typeface="Times New Roman" pitchFamily="18" charset="0"/>
              </a:rPr>
              <a:t> period (June to September) in 2015 and 2016.</a:t>
            </a:r>
            <a:endParaRPr kumimoji="1" lang="ja-JP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1907704"/>
            <a:ext cx="68580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kumimoji="1" lang="en-US" altLang="ja-JP" sz="1050" b="1" dirty="0" smtClean="0">
                <a:latin typeface="Times New Roman" pitchFamily="18" charset="0"/>
                <a:cs typeface="Times New Roman" pitchFamily="18" charset="0"/>
              </a:rPr>
              <a:t>S3. </a:t>
            </a:r>
            <a:r>
              <a:rPr kumimoji="1" lang="en-US" altLang="ja-JP" sz="1050" dirty="0" smtClean="0">
                <a:latin typeface="Times New Roman" pitchFamily="18" charset="0"/>
                <a:cs typeface="Times New Roman" pitchFamily="18" charset="0"/>
              </a:rPr>
              <a:t>Grain yield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, yield components and agronomic parameters of </a:t>
            </a:r>
            <a:r>
              <a:rPr kumimoji="1" lang="en-US" altLang="ja-JP" sz="1050" dirty="0" err="1">
                <a:latin typeface="Times New Roman" pitchFamily="18" charset="0"/>
                <a:cs typeface="Times New Roman" pitchFamily="18" charset="0"/>
              </a:rPr>
              <a:t>Koshihikari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 and Nona </a:t>
            </a:r>
            <a:r>
              <a:rPr kumimoji="1" lang="en-US" altLang="ja-JP" sz="1050" dirty="0" err="1">
                <a:latin typeface="Times New Roman" pitchFamily="18" charset="0"/>
                <a:cs typeface="Times New Roman" pitchFamily="18" charset="0"/>
              </a:rPr>
              <a:t>Bokra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 CSSLs </a:t>
            </a:r>
            <a:r>
              <a:rPr lang="en-US" altLang="ja-JP" sz="1050" dirty="0">
                <a:latin typeface="Times New Roman" pitchFamily="18" charset="0"/>
                <a:cs typeface="Times New Roman" pitchFamily="18" charset="0"/>
              </a:rPr>
              <a:t>under control and </a:t>
            </a:r>
            <a:r>
              <a:rPr lang="en-US" altLang="ja-JP" sz="1050" dirty="0" smtClean="0">
                <a:latin typeface="Times New Roman" pitchFamily="18" charset="0"/>
                <a:cs typeface="Times New Roman" pitchFamily="18" charset="0"/>
              </a:rPr>
              <a:t>saline </a:t>
            </a:r>
            <a:r>
              <a:rPr lang="en-US" altLang="ja-JP" sz="1050" dirty="0">
                <a:latin typeface="Times New Roman" pitchFamily="18" charset="0"/>
                <a:cs typeface="Times New Roman" pitchFamily="18" charset="0"/>
              </a:rPr>
              <a:t>conditions in 2015 and 2016.</a:t>
            </a:r>
            <a:endParaRPr kumimoji="1" lang="ja-JP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E588B9B8-9964-403C-A303-67C9A38D2C2B}"/>
              </a:ext>
            </a:extLst>
          </p:cNvPr>
          <p:cNvSpPr txBox="1"/>
          <p:nvPr/>
        </p:nvSpPr>
        <p:spPr>
          <a:xfrm>
            <a:off x="1" y="6948264"/>
            <a:ext cx="6597352" cy="936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smtClean="0">
                <a:latin typeface="Times New Roman" pitchFamily="18" charset="0"/>
                <a:cs typeface="Times New Roman" pitchFamily="18" charset="0"/>
              </a:rPr>
              <a:t>In 2015, the top 6 CSSLs with the highest SEI of panicle weight, the bottom 4 CSSLs with the lowest, and </a:t>
            </a:r>
            <a:r>
              <a:rPr lang="en-US" altLang="ja-JP" sz="1050" dirty="0" err="1" smtClean="0">
                <a:latin typeface="Times New Roman" pitchFamily="18" charset="0"/>
                <a:cs typeface="Times New Roman" pitchFamily="18" charset="0"/>
              </a:rPr>
              <a:t>Koshihikari</a:t>
            </a:r>
            <a:r>
              <a:rPr lang="en-US" altLang="ja-JP" sz="1050" dirty="0" smtClean="0">
                <a:latin typeface="Times New Roman" pitchFamily="18" charset="0"/>
                <a:cs typeface="Times New Roman" pitchFamily="18" charset="0"/>
              </a:rPr>
              <a:t>, were evaluated for grain yield and yield components. In 2016, the same CSSLs and </a:t>
            </a:r>
            <a:r>
              <a:rPr lang="en-US" altLang="ja-JP" sz="1050" dirty="0" err="1" smtClean="0">
                <a:latin typeface="Times New Roman" pitchFamily="18" charset="0"/>
                <a:cs typeface="Times New Roman" pitchFamily="18" charset="0"/>
              </a:rPr>
              <a:t>Koshihikari</a:t>
            </a:r>
            <a:r>
              <a:rPr lang="en-US" altLang="ja-JP" sz="1050" dirty="0" smtClean="0">
                <a:latin typeface="Times New Roman" pitchFamily="18" charset="0"/>
                <a:cs typeface="Times New Roman" pitchFamily="18" charset="0"/>
              </a:rPr>
              <a:t> were used for analyses except that SL502 was replaced to SL503. </a:t>
            </a:r>
            <a:r>
              <a:rPr kumimoji="1" lang="en-US" altLang="ja-JP" sz="1050" dirty="0" smtClean="0">
                <a:latin typeface="Times New Roman" pitchFamily="18" charset="0"/>
                <a:cs typeface="Times New Roman" pitchFamily="18" charset="0"/>
              </a:rPr>
              <a:t>*, 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** and *** indicate a significant difference from </a:t>
            </a:r>
            <a:r>
              <a:rPr kumimoji="1" lang="en-US" altLang="ja-JP" sz="1050" dirty="0" err="1">
                <a:latin typeface="Times New Roman" pitchFamily="18" charset="0"/>
                <a:cs typeface="Times New Roman" pitchFamily="18" charset="0"/>
              </a:rPr>
              <a:t>Koshihikari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 at P&lt;0.05, 0.01 and 0.001, respectively (</a:t>
            </a:r>
            <a:r>
              <a:rPr kumimoji="1" lang="en-US" altLang="ja-JP" sz="1050" dirty="0" err="1">
                <a:latin typeface="Times New Roman" pitchFamily="18" charset="0"/>
                <a:cs typeface="Times New Roman" pitchFamily="18" charset="0"/>
              </a:rPr>
              <a:t>Dunnett’s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 test</a:t>
            </a:r>
            <a:r>
              <a:rPr kumimoji="1" lang="en-US" altLang="ja-JP" sz="1050" dirty="0" smtClean="0">
                <a:latin typeface="Times New Roman" pitchFamily="18" charset="0"/>
                <a:cs typeface="Times New Roman" pitchFamily="18" charset="0"/>
              </a:rPr>
              <a:t>). In 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ANOVA, </a:t>
            </a:r>
            <a:r>
              <a:rPr kumimoji="1" lang="en-US" altLang="ja-JP" sz="1050" dirty="0" smtClean="0">
                <a:latin typeface="Times New Roman" pitchFamily="18" charset="0"/>
                <a:cs typeface="Times New Roman" pitchFamily="18" charset="0"/>
              </a:rPr>
              <a:t>*** indicates 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at the </a:t>
            </a:r>
            <a:r>
              <a:rPr kumimoji="1" lang="en-US" altLang="ja-JP" sz="1050" dirty="0" smtClean="0">
                <a:latin typeface="Times New Roman" pitchFamily="18" charset="0"/>
                <a:cs typeface="Times New Roman" pitchFamily="18" charset="0"/>
              </a:rPr>
              <a:t>0.1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% level </a:t>
            </a:r>
            <a:r>
              <a:rPr kumimoji="1" lang="en-US" altLang="ja-JP" sz="1050" dirty="0" smtClean="0">
                <a:latin typeface="Times New Roman" pitchFamily="18" charset="0"/>
                <a:cs typeface="Times New Roman" pitchFamily="18" charset="0"/>
              </a:rPr>
              <a:t>significance. </a:t>
            </a:r>
            <a:r>
              <a:rPr kumimoji="1" lang="en-US" altLang="ja-JP" sz="1050" dirty="0" err="1">
                <a:latin typeface="Times New Roman" pitchFamily="18" charset="0"/>
                <a:cs typeface="Times New Roman" pitchFamily="18" charset="0"/>
              </a:rPr>
              <a:t>n.s</a:t>
            </a:r>
            <a:r>
              <a:rPr kumimoji="1" lang="en-US" altLang="ja-JP" sz="1050" dirty="0">
                <a:latin typeface="Times New Roman" pitchFamily="18" charset="0"/>
                <a:cs typeface="Times New Roman" pitchFamily="18" charset="0"/>
              </a:rPr>
              <a:t>., not significant. </a:t>
            </a:r>
            <a:endParaRPr kumimoji="1" lang="ja-JP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6" name="表 5"/>
          <p:cNvGraphicFramePr>
            <a:graphicFrameLocks noGrp="1"/>
          </p:cNvGraphicFramePr>
          <p:nvPr/>
        </p:nvGraphicFramePr>
        <p:xfrm>
          <a:off x="0" y="2483768"/>
          <a:ext cx="6702153" cy="4187553"/>
        </p:xfrm>
        <a:graphic>
          <a:graphicData uri="http://schemas.openxmlformats.org/drawingml/2006/table">
            <a:tbl>
              <a:tblPr/>
              <a:tblGrid>
                <a:gridCol w="478985"/>
                <a:gridCol w="297551"/>
                <a:gridCol w="146961"/>
                <a:gridCol w="297551"/>
                <a:gridCol w="146961"/>
                <a:gridCol w="297551"/>
                <a:gridCol w="146961"/>
                <a:gridCol w="297551"/>
                <a:gridCol w="146961"/>
                <a:gridCol w="297551"/>
                <a:gridCol w="146961"/>
                <a:gridCol w="297551"/>
                <a:gridCol w="146961"/>
                <a:gridCol w="297551"/>
                <a:gridCol w="146961"/>
                <a:gridCol w="297551"/>
                <a:gridCol w="146961"/>
                <a:gridCol w="297551"/>
                <a:gridCol w="146961"/>
                <a:gridCol w="297551"/>
                <a:gridCol w="146961"/>
                <a:gridCol w="297551"/>
                <a:gridCol w="146961"/>
                <a:gridCol w="297551"/>
                <a:gridCol w="146961"/>
                <a:gridCol w="297551"/>
                <a:gridCol w="146961"/>
                <a:gridCol w="297551"/>
                <a:gridCol w="146961"/>
              </a:tblGrid>
              <a:tr h="9834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7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SSL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rain yield (g m</a:t>
                      </a:r>
                      <a:r>
                        <a:rPr lang="en-US" sz="600" b="0" i="0" u="none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-2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)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anicle number (m</a:t>
                      </a:r>
                      <a:r>
                        <a:rPr lang="en-US" sz="600" b="0" i="0" u="none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-2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)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pikelet number per panicle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rain weight (mg)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rain filling (%)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boveground biomass (g)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arvest index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lt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lt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lt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lt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lt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lt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lt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94826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5 experimental year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shihikari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02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42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2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8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6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9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9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7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4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1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5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1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51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0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4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4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4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8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5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2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4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3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6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2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83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7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9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3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3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3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1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7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0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6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5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7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95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7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4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5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7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8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2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8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7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6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1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36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3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44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8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0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7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8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6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8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0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2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7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2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16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8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6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8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3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2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3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1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7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6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4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13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8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75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08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2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8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6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2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2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3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5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4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04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9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4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3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3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6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4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9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1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3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7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8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18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26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6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57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4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8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1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7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4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2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6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5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9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97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9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4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64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4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7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5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5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3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4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3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1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91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2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36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87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0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8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0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7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8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3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8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2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04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87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4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08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0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8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9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5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2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9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3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7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67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6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5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9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9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5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3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7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6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7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2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V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9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9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4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3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1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6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6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7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1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7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7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4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6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1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826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6 experimental year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shihikari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80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8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6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9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9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2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2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9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0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8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9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1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8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6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0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3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4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8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7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2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3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7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6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2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0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5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7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3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7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0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6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7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69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4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3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7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8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8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5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6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9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3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4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1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94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5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0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58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7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1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2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0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3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3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6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2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43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1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0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4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8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4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2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2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4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7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0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4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37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2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2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45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0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4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4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3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8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3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2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4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91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1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2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6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1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3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2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2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5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8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6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8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91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3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5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7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6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7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3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6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4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4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3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9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52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0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0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5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2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1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2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8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6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6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1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1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37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1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0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34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9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8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1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3.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9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6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2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2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48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2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0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69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7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5.6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3.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0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8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9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0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86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4.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4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8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7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8.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.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.0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6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.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5.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1.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9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4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V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1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1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3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71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95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24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58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4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2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6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92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27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59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73 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826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nalysis of variance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5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ne (L)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reatment (T)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×T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.s.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.s.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6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ne (L)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reatment (T)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83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×T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.s.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***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463" marR="5463" marT="54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89</TotalTime>
  <Words>1728</Words>
  <Application>Microsoft Office PowerPoint</Application>
  <PresentationFormat>画面に合わせる (4:3)</PresentationFormat>
  <Paragraphs>1241</Paragraphs>
  <Slides>5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6" baseType="lpstr">
      <vt:lpstr>Office テーマ</vt:lpstr>
      <vt:lpstr>スライド 1</vt:lpstr>
      <vt:lpstr>スライド 2</vt:lpstr>
      <vt:lpstr>スライド 3</vt:lpstr>
      <vt:lpstr>スライド 4</vt:lpstr>
      <vt:lpstr>スライド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itsuya</dc:creator>
  <cp:lastModifiedBy>mitsuya</cp:lastModifiedBy>
  <cp:revision>602</cp:revision>
  <dcterms:created xsi:type="dcterms:W3CDTF">2017-07-17T05:54:48Z</dcterms:created>
  <dcterms:modified xsi:type="dcterms:W3CDTF">2019-06-28T06:40:48Z</dcterms:modified>
</cp:coreProperties>
</file>